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2" autoAdjust="0"/>
    <p:restoredTop sz="94660"/>
  </p:normalViewPr>
  <p:slideViewPr>
    <p:cSldViewPr snapToGrid="0">
      <p:cViewPr varScale="1">
        <p:scale>
          <a:sx n="89" d="100"/>
          <a:sy n="89" d="100"/>
        </p:scale>
        <p:origin x="16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45460-CA77-4CF2-A682-AC9D648BA074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8144-0A34-40D5-861F-6777D6B97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0017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45460-CA77-4CF2-A682-AC9D648BA074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8144-0A34-40D5-861F-6777D6B97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6620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45460-CA77-4CF2-A682-AC9D648BA074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8144-0A34-40D5-861F-6777D6B97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68106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45460-CA77-4CF2-A682-AC9D648BA074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8144-0A34-40D5-861F-6777D6B97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53352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45460-CA77-4CF2-A682-AC9D648BA074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8144-0A34-40D5-861F-6777D6B97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566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45460-CA77-4CF2-A682-AC9D648BA074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8144-0A34-40D5-861F-6777D6B97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1356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45460-CA77-4CF2-A682-AC9D648BA074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8144-0A34-40D5-861F-6777D6B97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1049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45460-CA77-4CF2-A682-AC9D648BA074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8144-0A34-40D5-861F-6777D6B97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261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45460-CA77-4CF2-A682-AC9D648BA074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8144-0A34-40D5-861F-6777D6B97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63429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45460-CA77-4CF2-A682-AC9D648BA074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8144-0A34-40D5-861F-6777D6B97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23430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45460-CA77-4CF2-A682-AC9D648BA074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8144-0A34-40D5-861F-6777D6B97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729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845460-CA77-4CF2-A682-AC9D648BA074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358144-0A34-40D5-861F-6777D6B97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03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480508" y="218778"/>
            <a:ext cx="10865223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estion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Choice ITPA (Interactive Tailored Patient Assessment) + assessment summaries to care team compared to Choice ITPA alone for cancer patients (leukemia, lymphoma, myeloma or with stem cell transplant) in routine interdisciplinary oncology practice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tting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University teaching hospital in Norway; all patients used a tablet during inpatient and prior to outpatient visits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bliography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1 </a:t>
            </a:r>
            <a:r>
              <a:rPr lang="en-US" dirty="0" err="1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Ruland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M, 2011 </a:t>
            </a:r>
            <a:endParaRPr lang="en-US" sz="20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7255487"/>
              </p:ext>
            </p:extLst>
          </p:nvPr>
        </p:nvGraphicFramePr>
        <p:xfrm>
          <a:off x="301213" y="2007394"/>
          <a:ext cx="11596747" cy="3820160"/>
        </p:xfrm>
        <a:graphic>
          <a:graphicData uri="http://schemas.openxmlformats.org/drawingml/2006/table">
            <a:tbl>
              <a:tblPr firstRow="1" firstCol="1" bandRow="1"/>
              <a:tblGrid>
                <a:gridCol w="869756">
                  <a:extLst>
                    <a:ext uri="{9D8B030D-6E8A-4147-A177-3AD203B41FA5}">
                      <a16:colId xmlns:a16="http://schemas.microsoft.com/office/drawing/2014/main" val="1145045175"/>
                    </a:ext>
                  </a:extLst>
                </a:gridCol>
                <a:gridCol w="869756">
                  <a:extLst>
                    <a:ext uri="{9D8B030D-6E8A-4147-A177-3AD203B41FA5}">
                      <a16:colId xmlns:a16="http://schemas.microsoft.com/office/drawing/2014/main" val="1842255545"/>
                    </a:ext>
                  </a:extLst>
                </a:gridCol>
                <a:gridCol w="869756">
                  <a:extLst>
                    <a:ext uri="{9D8B030D-6E8A-4147-A177-3AD203B41FA5}">
                      <a16:colId xmlns:a16="http://schemas.microsoft.com/office/drawing/2014/main" val="2297806172"/>
                    </a:ext>
                  </a:extLst>
                </a:gridCol>
                <a:gridCol w="869756">
                  <a:extLst>
                    <a:ext uri="{9D8B030D-6E8A-4147-A177-3AD203B41FA5}">
                      <a16:colId xmlns:a16="http://schemas.microsoft.com/office/drawing/2014/main" val="2918716859"/>
                    </a:ext>
                  </a:extLst>
                </a:gridCol>
                <a:gridCol w="869756">
                  <a:extLst>
                    <a:ext uri="{9D8B030D-6E8A-4147-A177-3AD203B41FA5}">
                      <a16:colId xmlns:a16="http://schemas.microsoft.com/office/drawing/2014/main" val="3556778216"/>
                    </a:ext>
                  </a:extLst>
                </a:gridCol>
                <a:gridCol w="869756">
                  <a:extLst>
                    <a:ext uri="{9D8B030D-6E8A-4147-A177-3AD203B41FA5}">
                      <a16:colId xmlns:a16="http://schemas.microsoft.com/office/drawing/2014/main" val="1990234676"/>
                    </a:ext>
                  </a:extLst>
                </a:gridCol>
                <a:gridCol w="869756">
                  <a:extLst>
                    <a:ext uri="{9D8B030D-6E8A-4147-A177-3AD203B41FA5}">
                      <a16:colId xmlns:a16="http://schemas.microsoft.com/office/drawing/2014/main" val="2973462926"/>
                    </a:ext>
                  </a:extLst>
                </a:gridCol>
                <a:gridCol w="869756">
                  <a:extLst>
                    <a:ext uri="{9D8B030D-6E8A-4147-A177-3AD203B41FA5}">
                      <a16:colId xmlns:a16="http://schemas.microsoft.com/office/drawing/2014/main" val="579806381"/>
                    </a:ext>
                  </a:extLst>
                </a:gridCol>
                <a:gridCol w="869756">
                  <a:extLst>
                    <a:ext uri="{9D8B030D-6E8A-4147-A177-3AD203B41FA5}">
                      <a16:colId xmlns:a16="http://schemas.microsoft.com/office/drawing/2014/main" val="1622778466"/>
                    </a:ext>
                  </a:extLst>
                </a:gridCol>
                <a:gridCol w="869756">
                  <a:extLst>
                    <a:ext uri="{9D8B030D-6E8A-4147-A177-3AD203B41FA5}">
                      <a16:colId xmlns:a16="http://schemas.microsoft.com/office/drawing/2014/main" val="3552561155"/>
                    </a:ext>
                  </a:extLst>
                </a:gridCol>
                <a:gridCol w="869756">
                  <a:extLst>
                    <a:ext uri="{9D8B030D-6E8A-4147-A177-3AD203B41FA5}">
                      <a16:colId xmlns:a16="http://schemas.microsoft.com/office/drawing/2014/main" val="1197979065"/>
                    </a:ext>
                  </a:extLst>
                </a:gridCol>
                <a:gridCol w="1159675">
                  <a:extLst>
                    <a:ext uri="{9D8B030D-6E8A-4147-A177-3AD203B41FA5}">
                      <a16:colId xmlns:a16="http://schemas.microsoft.com/office/drawing/2014/main" val="2778160009"/>
                    </a:ext>
                  </a:extLst>
                </a:gridCol>
                <a:gridCol w="869756">
                  <a:extLst>
                    <a:ext uri="{9D8B030D-6E8A-4147-A177-3AD203B41FA5}">
                      <a16:colId xmlns:a16="http://schemas.microsoft.com/office/drawing/2014/main" val="2150008622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 assessmen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patient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ffec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ortanc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879889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studie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udy desig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isk of bia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consistenc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directnes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recisio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ther consideration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hoice ITPA (Interactive Tailored Patient Assessment) + assessment summaries to care team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hoice ITPA alone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lativ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solut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00823557"/>
                  </a:ext>
                </a:extLst>
              </a:tr>
              <a:tr h="0">
                <a:tc gridSpan="1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physician inpatient chart entries addressing patient symptoms, problems, and concerns (follow up: variable; assessed with: chart audit (kappa 0.87 agreement beyond chance); Scale from: 0 to infinity)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305745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ndomized trials 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9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8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an </a:t>
                      </a:r>
                      <a:r>
                        <a:rPr lang="en-US" sz="1100" b="1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1 chart entries more</a:t>
                      </a:r>
                      <a: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0 to 0 ) 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  <a:cs typeface="Cambria" panose="02040503050406030204" pitchFamily="18" charset="0"/>
                        </a:rPr>
                        <a:t>⨁⨁</a:t>
                      </a:r>
                      <a:r>
                        <a:rPr lang="en-US" sz="1100" dirty="0" smtClean="0">
                          <a:effectLst/>
                          <a:latin typeface="MS Mincho" panose="02020609040205080304" pitchFamily="49" charset="-128"/>
                          <a:cs typeface="MS Mincho" panose="02020609040205080304" pitchFamily="49" charset="-128"/>
                        </a:rPr>
                        <a:t>◯◯</a:t>
                      </a:r>
                      <a: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7258767"/>
                  </a:ext>
                </a:extLst>
              </a:tr>
              <a:tr h="0">
                <a:tc gridSpan="1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outpatient physician chart entries addressing patient symptoms, problems, and concerns (follow up: variable; assessed with: chart audit; Scale from: 0 to infinity)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08323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ndomized trial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6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6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an </a:t>
                      </a:r>
                      <a:r>
                        <a:rPr lang="en-US" sz="1100" b="1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 chart entries more</a:t>
                      </a:r>
                      <a: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0 to 0 ) 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  <a:cs typeface="Cambria" panose="02040503050406030204" pitchFamily="18" charset="0"/>
                        </a:rPr>
                        <a:t>⨁⨁</a:t>
                      </a:r>
                      <a:r>
                        <a:rPr lang="en-US" sz="1100" dirty="0" smtClean="0">
                          <a:effectLst/>
                          <a:latin typeface="MS Mincho" panose="02020609040205080304" pitchFamily="49" charset="-128"/>
                          <a:cs typeface="MS Mincho" panose="02020609040205080304" pitchFamily="49" charset="-128"/>
                        </a:rPr>
                        <a:t>◯◯</a:t>
                      </a:r>
                      <a: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dirty="0" smtClean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2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940195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3719204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505608" y="370734"/>
            <a:ext cx="11317045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estion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ESRA-C (</a:t>
            </a:r>
            <a:r>
              <a:rPr lang="en-US" dirty="0" err="1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Self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-Report Assessment with clinician summary, patient education, and coaching) compared to enhanced usual care (self-report and clinician summary) for patients with cancer starting a new therapeutic regimen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tting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ambulatory care at 2 comprehensive cancer centers (Fred Hutchinson's transplantation service; and Dana-Farber's medical and radiation oncology)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bliography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10 Berry DL, 2014 </a:t>
            </a:r>
            <a:endParaRPr lang="en-US" sz="20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94671381"/>
              </p:ext>
            </p:extLst>
          </p:nvPr>
        </p:nvGraphicFramePr>
        <p:xfrm>
          <a:off x="311972" y="2286159"/>
          <a:ext cx="11510681" cy="2927350"/>
        </p:xfrm>
        <a:graphic>
          <a:graphicData uri="http://schemas.openxmlformats.org/drawingml/2006/table">
            <a:tbl>
              <a:tblPr firstRow="1" firstCol="1" bandRow="1"/>
              <a:tblGrid>
                <a:gridCol w="863301">
                  <a:extLst>
                    <a:ext uri="{9D8B030D-6E8A-4147-A177-3AD203B41FA5}">
                      <a16:colId xmlns:a16="http://schemas.microsoft.com/office/drawing/2014/main" val="878732662"/>
                    </a:ext>
                  </a:extLst>
                </a:gridCol>
                <a:gridCol w="863301">
                  <a:extLst>
                    <a:ext uri="{9D8B030D-6E8A-4147-A177-3AD203B41FA5}">
                      <a16:colId xmlns:a16="http://schemas.microsoft.com/office/drawing/2014/main" val="3858020681"/>
                    </a:ext>
                  </a:extLst>
                </a:gridCol>
                <a:gridCol w="863301">
                  <a:extLst>
                    <a:ext uri="{9D8B030D-6E8A-4147-A177-3AD203B41FA5}">
                      <a16:colId xmlns:a16="http://schemas.microsoft.com/office/drawing/2014/main" val="4104201131"/>
                    </a:ext>
                  </a:extLst>
                </a:gridCol>
                <a:gridCol w="863301">
                  <a:extLst>
                    <a:ext uri="{9D8B030D-6E8A-4147-A177-3AD203B41FA5}">
                      <a16:colId xmlns:a16="http://schemas.microsoft.com/office/drawing/2014/main" val="173919764"/>
                    </a:ext>
                  </a:extLst>
                </a:gridCol>
                <a:gridCol w="863301">
                  <a:extLst>
                    <a:ext uri="{9D8B030D-6E8A-4147-A177-3AD203B41FA5}">
                      <a16:colId xmlns:a16="http://schemas.microsoft.com/office/drawing/2014/main" val="2867562893"/>
                    </a:ext>
                  </a:extLst>
                </a:gridCol>
                <a:gridCol w="863301">
                  <a:extLst>
                    <a:ext uri="{9D8B030D-6E8A-4147-A177-3AD203B41FA5}">
                      <a16:colId xmlns:a16="http://schemas.microsoft.com/office/drawing/2014/main" val="3879405527"/>
                    </a:ext>
                  </a:extLst>
                </a:gridCol>
                <a:gridCol w="863301">
                  <a:extLst>
                    <a:ext uri="{9D8B030D-6E8A-4147-A177-3AD203B41FA5}">
                      <a16:colId xmlns:a16="http://schemas.microsoft.com/office/drawing/2014/main" val="2380021072"/>
                    </a:ext>
                  </a:extLst>
                </a:gridCol>
                <a:gridCol w="863301">
                  <a:extLst>
                    <a:ext uri="{9D8B030D-6E8A-4147-A177-3AD203B41FA5}">
                      <a16:colId xmlns:a16="http://schemas.microsoft.com/office/drawing/2014/main" val="3150873074"/>
                    </a:ext>
                  </a:extLst>
                </a:gridCol>
                <a:gridCol w="863301">
                  <a:extLst>
                    <a:ext uri="{9D8B030D-6E8A-4147-A177-3AD203B41FA5}">
                      <a16:colId xmlns:a16="http://schemas.microsoft.com/office/drawing/2014/main" val="173001462"/>
                    </a:ext>
                  </a:extLst>
                </a:gridCol>
                <a:gridCol w="863301">
                  <a:extLst>
                    <a:ext uri="{9D8B030D-6E8A-4147-A177-3AD203B41FA5}">
                      <a16:colId xmlns:a16="http://schemas.microsoft.com/office/drawing/2014/main" val="1989599636"/>
                    </a:ext>
                  </a:extLst>
                </a:gridCol>
                <a:gridCol w="863301">
                  <a:extLst>
                    <a:ext uri="{9D8B030D-6E8A-4147-A177-3AD203B41FA5}">
                      <a16:colId xmlns:a16="http://schemas.microsoft.com/office/drawing/2014/main" val="451830610"/>
                    </a:ext>
                  </a:extLst>
                </a:gridCol>
                <a:gridCol w="1151069">
                  <a:extLst>
                    <a:ext uri="{9D8B030D-6E8A-4147-A177-3AD203B41FA5}">
                      <a16:colId xmlns:a16="http://schemas.microsoft.com/office/drawing/2014/main" val="2457716850"/>
                    </a:ext>
                  </a:extLst>
                </a:gridCol>
                <a:gridCol w="863301">
                  <a:extLst>
                    <a:ext uri="{9D8B030D-6E8A-4147-A177-3AD203B41FA5}">
                      <a16:colId xmlns:a16="http://schemas.microsoft.com/office/drawing/2014/main" val="437313436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 assessmen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patient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ffec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ortanc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04266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studie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udy desig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isk of bia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consistenc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directnes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recisio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ther consideration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SRA-C (eSelf-Report Assessment with clinician summary, patient education, and coaching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nhanced usual care (self-report and clinician summary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lativ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solut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82979491"/>
                  </a:ext>
                </a:extLst>
              </a:tr>
              <a:tr h="0">
                <a:tc gridSpan="1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ymptom Distress (follow up: 4 weeks; assessed with: 15-item Symptom Distress Scale; Scale from: 15 to 75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12288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ndomized trial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89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92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an </a:t>
                      </a: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27 points lower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0.23 lower to 2.2 lower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  <a:cs typeface="Cambria" panose="02040503050406030204" pitchFamily="18" charset="0"/>
                        </a:rPr>
                        <a:t>⨁⨁⨁</a:t>
                      </a:r>
                      <a:r>
                        <a:rPr lang="en-US" sz="1100">
                          <a:effectLst/>
                          <a:latin typeface="MS Mincho" panose="02020609040205080304" pitchFamily="49" charset="-128"/>
                          <a:ea typeface="Times New Roman" panose="02020603050405020304" pitchFamily="18" charset="0"/>
                          <a:cs typeface="MS Mincho" panose="02020609040205080304" pitchFamily="49" charset="-128"/>
                        </a:rPr>
                        <a:t>◯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DERATE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2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308538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630683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451821" y="389550"/>
            <a:ext cx="1156447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estion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dirty="0" err="1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bChoice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Web-based illness management support system) + IPPC (Internet-based Patient-Provider Communication services) compared to Usual Care for patients recently diagnosed with breast cancer and undergoing treatment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tting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3 Norwegian hospitals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bliography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11 </a:t>
            </a:r>
            <a:r>
              <a:rPr lang="en-US" dirty="0" err="1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ørøsund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, 2014 </a:t>
            </a:r>
            <a:endParaRPr lang="en-US" sz="20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81950798"/>
              </p:ext>
            </p:extLst>
          </p:nvPr>
        </p:nvGraphicFramePr>
        <p:xfrm>
          <a:off x="279700" y="1804200"/>
          <a:ext cx="11489168" cy="4357927"/>
        </p:xfrm>
        <a:graphic>
          <a:graphicData uri="http://schemas.openxmlformats.org/drawingml/2006/table">
            <a:tbl>
              <a:tblPr firstRow="1" firstCol="1" bandRow="1"/>
              <a:tblGrid>
                <a:gridCol w="625011">
                  <a:extLst>
                    <a:ext uri="{9D8B030D-6E8A-4147-A177-3AD203B41FA5}">
                      <a16:colId xmlns:a16="http://schemas.microsoft.com/office/drawing/2014/main" val="1767061077"/>
                    </a:ext>
                  </a:extLst>
                </a:gridCol>
                <a:gridCol w="912241">
                  <a:extLst>
                    <a:ext uri="{9D8B030D-6E8A-4147-A177-3AD203B41FA5}">
                      <a16:colId xmlns:a16="http://schemas.microsoft.com/office/drawing/2014/main" val="3875660383"/>
                    </a:ext>
                  </a:extLst>
                </a:gridCol>
                <a:gridCol w="625011">
                  <a:extLst>
                    <a:ext uri="{9D8B030D-6E8A-4147-A177-3AD203B41FA5}">
                      <a16:colId xmlns:a16="http://schemas.microsoft.com/office/drawing/2014/main" val="1918061685"/>
                    </a:ext>
                  </a:extLst>
                </a:gridCol>
                <a:gridCol w="1082280">
                  <a:extLst>
                    <a:ext uri="{9D8B030D-6E8A-4147-A177-3AD203B41FA5}">
                      <a16:colId xmlns:a16="http://schemas.microsoft.com/office/drawing/2014/main" val="711686831"/>
                    </a:ext>
                  </a:extLst>
                </a:gridCol>
                <a:gridCol w="969687">
                  <a:extLst>
                    <a:ext uri="{9D8B030D-6E8A-4147-A177-3AD203B41FA5}">
                      <a16:colId xmlns:a16="http://schemas.microsoft.com/office/drawing/2014/main" val="1175803353"/>
                    </a:ext>
                  </a:extLst>
                </a:gridCol>
                <a:gridCol w="928324">
                  <a:extLst>
                    <a:ext uri="{9D8B030D-6E8A-4147-A177-3AD203B41FA5}">
                      <a16:colId xmlns:a16="http://schemas.microsoft.com/office/drawing/2014/main" val="2959329549"/>
                    </a:ext>
                  </a:extLst>
                </a:gridCol>
                <a:gridCol w="1144320">
                  <a:extLst>
                    <a:ext uri="{9D8B030D-6E8A-4147-A177-3AD203B41FA5}">
                      <a16:colId xmlns:a16="http://schemas.microsoft.com/office/drawing/2014/main" val="1700775986"/>
                    </a:ext>
                  </a:extLst>
                </a:gridCol>
                <a:gridCol w="1208659">
                  <a:extLst>
                    <a:ext uri="{9D8B030D-6E8A-4147-A177-3AD203B41FA5}">
                      <a16:colId xmlns:a16="http://schemas.microsoft.com/office/drawing/2014/main" val="2217300369"/>
                    </a:ext>
                  </a:extLst>
                </a:gridCol>
                <a:gridCol w="627309">
                  <a:extLst>
                    <a:ext uri="{9D8B030D-6E8A-4147-A177-3AD203B41FA5}">
                      <a16:colId xmlns:a16="http://schemas.microsoft.com/office/drawing/2014/main" val="698293453"/>
                    </a:ext>
                  </a:extLst>
                </a:gridCol>
                <a:gridCol w="723817">
                  <a:extLst>
                    <a:ext uri="{9D8B030D-6E8A-4147-A177-3AD203B41FA5}">
                      <a16:colId xmlns:a16="http://schemas.microsoft.com/office/drawing/2014/main" val="3171119733"/>
                    </a:ext>
                  </a:extLst>
                </a:gridCol>
                <a:gridCol w="735307">
                  <a:extLst>
                    <a:ext uri="{9D8B030D-6E8A-4147-A177-3AD203B41FA5}">
                      <a16:colId xmlns:a16="http://schemas.microsoft.com/office/drawing/2014/main" val="1494644269"/>
                    </a:ext>
                  </a:extLst>
                </a:gridCol>
                <a:gridCol w="953601">
                  <a:extLst>
                    <a:ext uri="{9D8B030D-6E8A-4147-A177-3AD203B41FA5}">
                      <a16:colId xmlns:a16="http://schemas.microsoft.com/office/drawing/2014/main" val="2219028402"/>
                    </a:ext>
                  </a:extLst>
                </a:gridCol>
                <a:gridCol w="953601">
                  <a:extLst>
                    <a:ext uri="{9D8B030D-6E8A-4147-A177-3AD203B41FA5}">
                      <a16:colId xmlns:a16="http://schemas.microsoft.com/office/drawing/2014/main" val="901190116"/>
                    </a:ext>
                  </a:extLst>
                </a:gridCol>
              </a:tblGrid>
              <a:tr h="235546">
                <a:tc gridSpan="7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 assessment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671" marR="42671" marT="42671" marB="4267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patient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671" marR="42671" marT="42671" marB="4267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ffec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671" marR="42671" marT="42671" marB="4267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671" marR="42671" marT="42671" marB="4267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ortanc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671" marR="42671" marT="42671" marB="4267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66482781"/>
                  </a:ext>
                </a:extLst>
              </a:tr>
              <a:tr h="1314277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studie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671" marR="42671" marT="42671" marB="4267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udy desig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671" marR="42671" marT="42671" marB="4267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isk of bia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671" marR="42671" marT="42671" marB="4267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consistency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671" marR="42671" marT="42671" marB="4267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directnes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671" marR="42671" marT="42671" marB="4267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recisio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671" marR="42671" marT="42671" marB="4267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ther consideration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671" marR="42671" marT="42671" marB="4267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ebChoice (Web-based illness management support system) + IPPC (Internet-based Patient-Provider Communication services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671" marR="42671" marT="42671" marB="4267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sual Car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671" marR="42671" marT="42671" marB="4267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lative</a:t>
                      </a:r>
                      <a:br>
                        <a:rPr lang="en-US" sz="10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0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671" marR="42671" marT="42671" marB="4267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solute</a:t>
                      </a:r>
                      <a:br>
                        <a:rPr lang="en-US" sz="10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0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671" marR="42671" marT="42671" marB="4267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05841854"/>
                  </a:ext>
                </a:extLst>
              </a:tr>
              <a:tr h="235546">
                <a:tc gridSpan="1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ymptom Distress (assessed with: 32-item Memorial Symptom Assessment Scale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671" marR="42671" marT="42671" marB="4267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2736482"/>
                  </a:ext>
                </a:extLst>
              </a:tr>
              <a:tr h="1165212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ndomized trials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ery serious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4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8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an </a:t>
                      </a:r>
                      <a:r>
                        <a:rPr lang="en-US" sz="10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6 points lower</a:t>
                      </a: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0.25 lower to 0.06 lower)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  <a:cs typeface="Cambria" panose="02040503050406030204" pitchFamily="18" charset="0"/>
                        </a:rPr>
                        <a:t>⨁</a:t>
                      </a:r>
                      <a:r>
                        <a:rPr lang="en-US" sz="1000">
                          <a:effectLst/>
                          <a:latin typeface="MS Mincho" panose="02020609040205080304" pitchFamily="49" charset="-128"/>
                          <a:ea typeface="Times New Roman" panose="02020603050405020304" pitchFamily="18" charset="0"/>
                          <a:cs typeface="MS Mincho" panose="02020609040205080304" pitchFamily="49" charset="-128"/>
                        </a:rPr>
                        <a:t>◯◯◯</a:t>
                      </a: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ERY LOW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1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1214155"/>
                  </a:ext>
                </a:extLst>
              </a:tr>
              <a:tr h="235546">
                <a:tc gridSpan="1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xiety/Depression (assessed with: Hospital Anxiety and Depression Scale (14-item self-report measure)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671" marR="42671" marT="42671" marB="42671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67248392"/>
                  </a:ext>
                </a:extLst>
              </a:tr>
              <a:tr h="1165212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ndomized trials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ery serious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4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8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an </a:t>
                      </a:r>
                      <a:r>
                        <a:rPr lang="en-US" sz="10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9 points lower</a:t>
                      </a: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1.18 lower to 0.05 lower)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  <a:cs typeface="Cambria" panose="02040503050406030204" pitchFamily="18" charset="0"/>
                        </a:rPr>
                        <a:t>⨁</a:t>
                      </a:r>
                      <a:r>
                        <a:rPr lang="en-US" sz="1000">
                          <a:effectLst/>
                          <a:latin typeface="MS Mincho" panose="02020609040205080304" pitchFamily="49" charset="-128"/>
                          <a:ea typeface="Times New Roman" panose="02020603050405020304" pitchFamily="18" charset="0"/>
                          <a:cs typeface="MS Mincho" panose="02020609040205080304" pitchFamily="49" charset="-128"/>
                        </a:rPr>
                        <a:t>◯◯◯</a:t>
                      </a: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0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ERY LOW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1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895" marR="56895" marT="56895" marB="5689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381421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1970947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90458" y="518642"/>
            <a:ext cx="1183341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estion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E-FAP (e-Follow-up Application; a web-mediated prompting of follow-up imaging) compared to scheduled interval imaging for patients with advanced lung cancer without evidence of disease progression after or during initial treatment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tting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five hospitals and clinics in France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bliography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12 Denis F, 2017 </a:t>
            </a:r>
            <a:endParaRPr lang="en-US" sz="20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1386481"/>
              </p:ext>
            </p:extLst>
          </p:nvPr>
        </p:nvGraphicFramePr>
        <p:xfrm>
          <a:off x="290458" y="2054711"/>
          <a:ext cx="11510681" cy="3116374"/>
        </p:xfrm>
        <a:graphic>
          <a:graphicData uri="http://schemas.openxmlformats.org/drawingml/2006/table">
            <a:tbl>
              <a:tblPr firstRow="1" firstCol="1" bandRow="1"/>
              <a:tblGrid>
                <a:gridCol w="863301">
                  <a:extLst>
                    <a:ext uri="{9D8B030D-6E8A-4147-A177-3AD203B41FA5}">
                      <a16:colId xmlns:a16="http://schemas.microsoft.com/office/drawing/2014/main" val="3794219715"/>
                    </a:ext>
                  </a:extLst>
                </a:gridCol>
                <a:gridCol w="863301">
                  <a:extLst>
                    <a:ext uri="{9D8B030D-6E8A-4147-A177-3AD203B41FA5}">
                      <a16:colId xmlns:a16="http://schemas.microsoft.com/office/drawing/2014/main" val="4259024450"/>
                    </a:ext>
                  </a:extLst>
                </a:gridCol>
                <a:gridCol w="863301">
                  <a:extLst>
                    <a:ext uri="{9D8B030D-6E8A-4147-A177-3AD203B41FA5}">
                      <a16:colId xmlns:a16="http://schemas.microsoft.com/office/drawing/2014/main" val="1905332944"/>
                    </a:ext>
                  </a:extLst>
                </a:gridCol>
                <a:gridCol w="863301">
                  <a:extLst>
                    <a:ext uri="{9D8B030D-6E8A-4147-A177-3AD203B41FA5}">
                      <a16:colId xmlns:a16="http://schemas.microsoft.com/office/drawing/2014/main" val="1393178049"/>
                    </a:ext>
                  </a:extLst>
                </a:gridCol>
                <a:gridCol w="863301">
                  <a:extLst>
                    <a:ext uri="{9D8B030D-6E8A-4147-A177-3AD203B41FA5}">
                      <a16:colId xmlns:a16="http://schemas.microsoft.com/office/drawing/2014/main" val="1555433445"/>
                    </a:ext>
                  </a:extLst>
                </a:gridCol>
                <a:gridCol w="863301">
                  <a:extLst>
                    <a:ext uri="{9D8B030D-6E8A-4147-A177-3AD203B41FA5}">
                      <a16:colId xmlns:a16="http://schemas.microsoft.com/office/drawing/2014/main" val="3627693758"/>
                    </a:ext>
                  </a:extLst>
                </a:gridCol>
                <a:gridCol w="863301">
                  <a:extLst>
                    <a:ext uri="{9D8B030D-6E8A-4147-A177-3AD203B41FA5}">
                      <a16:colId xmlns:a16="http://schemas.microsoft.com/office/drawing/2014/main" val="1547380635"/>
                    </a:ext>
                  </a:extLst>
                </a:gridCol>
                <a:gridCol w="863301">
                  <a:extLst>
                    <a:ext uri="{9D8B030D-6E8A-4147-A177-3AD203B41FA5}">
                      <a16:colId xmlns:a16="http://schemas.microsoft.com/office/drawing/2014/main" val="463653092"/>
                    </a:ext>
                  </a:extLst>
                </a:gridCol>
                <a:gridCol w="863301">
                  <a:extLst>
                    <a:ext uri="{9D8B030D-6E8A-4147-A177-3AD203B41FA5}">
                      <a16:colId xmlns:a16="http://schemas.microsoft.com/office/drawing/2014/main" val="1719199468"/>
                    </a:ext>
                  </a:extLst>
                </a:gridCol>
                <a:gridCol w="863301">
                  <a:extLst>
                    <a:ext uri="{9D8B030D-6E8A-4147-A177-3AD203B41FA5}">
                      <a16:colId xmlns:a16="http://schemas.microsoft.com/office/drawing/2014/main" val="3761839401"/>
                    </a:ext>
                  </a:extLst>
                </a:gridCol>
                <a:gridCol w="863301">
                  <a:extLst>
                    <a:ext uri="{9D8B030D-6E8A-4147-A177-3AD203B41FA5}">
                      <a16:colId xmlns:a16="http://schemas.microsoft.com/office/drawing/2014/main" val="2612903210"/>
                    </a:ext>
                  </a:extLst>
                </a:gridCol>
                <a:gridCol w="1151069">
                  <a:extLst>
                    <a:ext uri="{9D8B030D-6E8A-4147-A177-3AD203B41FA5}">
                      <a16:colId xmlns:a16="http://schemas.microsoft.com/office/drawing/2014/main" val="1666679414"/>
                    </a:ext>
                  </a:extLst>
                </a:gridCol>
                <a:gridCol w="863301">
                  <a:extLst>
                    <a:ext uri="{9D8B030D-6E8A-4147-A177-3AD203B41FA5}">
                      <a16:colId xmlns:a16="http://schemas.microsoft.com/office/drawing/2014/main" val="4002491343"/>
                    </a:ext>
                  </a:extLst>
                </a:gridCol>
              </a:tblGrid>
              <a:tr h="315140">
                <a:tc gridSpan="7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 assessmen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patient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ffec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ortance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72048688"/>
                  </a:ext>
                </a:extLst>
              </a:tr>
              <a:tr h="152089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studie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udy desig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isk of bia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consistenc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directnes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recisio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ther considerations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-FAP (e-Follow-up Application; a web-mediated prompting of follow-up imaging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cheduled interval imaging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lativ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solut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28493528"/>
                  </a:ext>
                </a:extLst>
              </a:tr>
              <a:tr h="315140">
                <a:tc gridSpan="1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verall Survival (follow up: 1 years; assessed with: defined from random assignment to death or to the last assessment of patient’s status when the patient was censored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88273442"/>
                  </a:ext>
                </a:extLst>
              </a:tr>
              <a:tr h="956077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ndomized trial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1/60 (18.3%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6/61 (42.6%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R 0.32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0.15 to 0.67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6 fewer per 100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from 12 fewer to 35 fewer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  <a:cs typeface="Cambria" panose="02040503050406030204" pitchFamily="18" charset="0"/>
                        </a:rPr>
                        <a:t>⨁⨁⨁</a:t>
                      </a:r>
                      <a:r>
                        <a:rPr lang="en-US" sz="1100">
                          <a:effectLst/>
                          <a:latin typeface="MS Mincho" panose="02020609040205080304" pitchFamily="49" charset="-128"/>
                          <a:ea typeface="Times New Roman" panose="02020603050405020304" pitchFamily="18" charset="0"/>
                          <a:cs typeface="MS Mincho" panose="02020609040205080304" pitchFamily="49" charset="-128"/>
                        </a:rPr>
                        <a:t>◯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DERATE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2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242668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6634030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118797" y="833313"/>
            <a:ext cx="10133702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estion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Web-based cessation program with high-depth tailoring + nicotine patch compared to web-based cessation program with low-depth tailoring + nicotine patch for adult smokers (at least 100 lifetime cigarettes and currently 10 per day) seriously considering quitting within 30 days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tting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Group Health of Seattle WA and Henry Ford Health System of Detroit MI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bliography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13 </a:t>
            </a:r>
            <a:r>
              <a:rPr lang="en-US" dirty="0" err="1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echer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J, 2008 </a:t>
            </a:r>
            <a:endParaRPr lang="en-US" sz="20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24474896"/>
              </p:ext>
            </p:extLst>
          </p:nvPr>
        </p:nvGraphicFramePr>
        <p:xfrm>
          <a:off x="182880" y="2537619"/>
          <a:ext cx="11779626" cy="2424430"/>
        </p:xfrm>
        <a:graphic>
          <a:graphicData uri="http://schemas.openxmlformats.org/drawingml/2006/table">
            <a:tbl>
              <a:tblPr firstRow="1" firstCol="1" bandRow="1"/>
              <a:tblGrid>
                <a:gridCol w="883472">
                  <a:extLst>
                    <a:ext uri="{9D8B030D-6E8A-4147-A177-3AD203B41FA5}">
                      <a16:colId xmlns:a16="http://schemas.microsoft.com/office/drawing/2014/main" val="1022888461"/>
                    </a:ext>
                  </a:extLst>
                </a:gridCol>
                <a:gridCol w="883472">
                  <a:extLst>
                    <a:ext uri="{9D8B030D-6E8A-4147-A177-3AD203B41FA5}">
                      <a16:colId xmlns:a16="http://schemas.microsoft.com/office/drawing/2014/main" val="1739222947"/>
                    </a:ext>
                  </a:extLst>
                </a:gridCol>
                <a:gridCol w="883472">
                  <a:extLst>
                    <a:ext uri="{9D8B030D-6E8A-4147-A177-3AD203B41FA5}">
                      <a16:colId xmlns:a16="http://schemas.microsoft.com/office/drawing/2014/main" val="1198214233"/>
                    </a:ext>
                  </a:extLst>
                </a:gridCol>
                <a:gridCol w="883472">
                  <a:extLst>
                    <a:ext uri="{9D8B030D-6E8A-4147-A177-3AD203B41FA5}">
                      <a16:colId xmlns:a16="http://schemas.microsoft.com/office/drawing/2014/main" val="3146700452"/>
                    </a:ext>
                  </a:extLst>
                </a:gridCol>
                <a:gridCol w="883472">
                  <a:extLst>
                    <a:ext uri="{9D8B030D-6E8A-4147-A177-3AD203B41FA5}">
                      <a16:colId xmlns:a16="http://schemas.microsoft.com/office/drawing/2014/main" val="2297864983"/>
                    </a:ext>
                  </a:extLst>
                </a:gridCol>
                <a:gridCol w="883472">
                  <a:extLst>
                    <a:ext uri="{9D8B030D-6E8A-4147-A177-3AD203B41FA5}">
                      <a16:colId xmlns:a16="http://schemas.microsoft.com/office/drawing/2014/main" val="3939640286"/>
                    </a:ext>
                  </a:extLst>
                </a:gridCol>
                <a:gridCol w="883472">
                  <a:extLst>
                    <a:ext uri="{9D8B030D-6E8A-4147-A177-3AD203B41FA5}">
                      <a16:colId xmlns:a16="http://schemas.microsoft.com/office/drawing/2014/main" val="799334004"/>
                    </a:ext>
                  </a:extLst>
                </a:gridCol>
                <a:gridCol w="883472">
                  <a:extLst>
                    <a:ext uri="{9D8B030D-6E8A-4147-A177-3AD203B41FA5}">
                      <a16:colId xmlns:a16="http://schemas.microsoft.com/office/drawing/2014/main" val="1761044246"/>
                    </a:ext>
                  </a:extLst>
                </a:gridCol>
                <a:gridCol w="883472">
                  <a:extLst>
                    <a:ext uri="{9D8B030D-6E8A-4147-A177-3AD203B41FA5}">
                      <a16:colId xmlns:a16="http://schemas.microsoft.com/office/drawing/2014/main" val="1212018793"/>
                    </a:ext>
                  </a:extLst>
                </a:gridCol>
                <a:gridCol w="883472">
                  <a:extLst>
                    <a:ext uri="{9D8B030D-6E8A-4147-A177-3AD203B41FA5}">
                      <a16:colId xmlns:a16="http://schemas.microsoft.com/office/drawing/2014/main" val="1793699275"/>
                    </a:ext>
                  </a:extLst>
                </a:gridCol>
                <a:gridCol w="883472">
                  <a:extLst>
                    <a:ext uri="{9D8B030D-6E8A-4147-A177-3AD203B41FA5}">
                      <a16:colId xmlns:a16="http://schemas.microsoft.com/office/drawing/2014/main" val="862871273"/>
                    </a:ext>
                  </a:extLst>
                </a:gridCol>
                <a:gridCol w="1177962">
                  <a:extLst>
                    <a:ext uri="{9D8B030D-6E8A-4147-A177-3AD203B41FA5}">
                      <a16:colId xmlns:a16="http://schemas.microsoft.com/office/drawing/2014/main" val="738721081"/>
                    </a:ext>
                  </a:extLst>
                </a:gridCol>
                <a:gridCol w="883472">
                  <a:extLst>
                    <a:ext uri="{9D8B030D-6E8A-4147-A177-3AD203B41FA5}">
                      <a16:colId xmlns:a16="http://schemas.microsoft.com/office/drawing/2014/main" val="3666621432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 assessmen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patient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ffec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ortanc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92453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studie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udy desig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isk of bia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consistenc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directnes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recisio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ther consideration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eb-based cessation program with high-depth tailoring + nicotine patch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eb-based cessation program with low-depth tailoring + nicotine patch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lativ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solut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27244977"/>
                  </a:ext>
                </a:extLst>
              </a:tr>
              <a:tr h="0">
                <a:tc gridSpan="1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-month cessation rate (assessed with: 7-day point prevalence abstinence at 6-months assessed by self-report during telephone interview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779460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ndomized trial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7/488 (34.2%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2/456 (26.8%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R 1.91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1.18 to 3.11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3 more per 1,000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from 34 more to 264 more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  <a:cs typeface="Cambria" panose="02040503050406030204" pitchFamily="18" charset="0"/>
                        </a:rPr>
                        <a:t>⨁⨁⨁</a:t>
                      </a:r>
                      <a:r>
                        <a:rPr lang="en-US" sz="1100">
                          <a:effectLst/>
                          <a:latin typeface="MS Mincho" panose="02020609040205080304" pitchFamily="49" charset="-128"/>
                          <a:ea typeface="Times New Roman" panose="02020603050405020304" pitchFamily="18" charset="0"/>
                          <a:cs typeface="MS Mincho" panose="02020609040205080304" pitchFamily="49" charset="-128"/>
                        </a:rPr>
                        <a:t>◯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DERATE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2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661594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3979691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505610" y="1012143"/>
            <a:ext cx="1136007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estion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Text2Quit compared to Online self-help material (control) for US adult smokers (&gt;= 5 cigarettes per day) interested in quitting &amp; with unlimited text messaging plans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tting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community-based internet recruitment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bliography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14 </a:t>
            </a:r>
            <a:r>
              <a:rPr lang="en-US" dirty="0" err="1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broms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L, 2014 </a:t>
            </a:r>
            <a:endParaRPr lang="en-US" sz="20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97000417"/>
              </p:ext>
            </p:extLst>
          </p:nvPr>
        </p:nvGraphicFramePr>
        <p:xfrm>
          <a:off x="408790" y="2956719"/>
          <a:ext cx="11456895" cy="1921510"/>
        </p:xfrm>
        <a:graphic>
          <a:graphicData uri="http://schemas.openxmlformats.org/drawingml/2006/table">
            <a:tbl>
              <a:tblPr firstRow="1" firstCol="1" bandRow="1"/>
              <a:tblGrid>
                <a:gridCol w="859267">
                  <a:extLst>
                    <a:ext uri="{9D8B030D-6E8A-4147-A177-3AD203B41FA5}">
                      <a16:colId xmlns:a16="http://schemas.microsoft.com/office/drawing/2014/main" val="3262532189"/>
                    </a:ext>
                  </a:extLst>
                </a:gridCol>
                <a:gridCol w="859267">
                  <a:extLst>
                    <a:ext uri="{9D8B030D-6E8A-4147-A177-3AD203B41FA5}">
                      <a16:colId xmlns:a16="http://schemas.microsoft.com/office/drawing/2014/main" val="3703546658"/>
                    </a:ext>
                  </a:extLst>
                </a:gridCol>
                <a:gridCol w="859267">
                  <a:extLst>
                    <a:ext uri="{9D8B030D-6E8A-4147-A177-3AD203B41FA5}">
                      <a16:colId xmlns:a16="http://schemas.microsoft.com/office/drawing/2014/main" val="2445667638"/>
                    </a:ext>
                  </a:extLst>
                </a:gridCol>
                <a:gridCol w="859267">
                  <a:extLst>
                    <a:ext uri="{9D8B030D-6E8A-4147-A177-3AD203B41FA5}">
                      <a16:colId xmlns:a16="http://schemas.microsoft.com/office/drawing/2014/main" val="556687635"/>
                    </a:ext>
                  </a:extLst>
                </a:gridCol>
                <a:gridCol w="859267">
                  <a:extLst>
                    <a:ext uri="{9D8B030D-6E8A-4147-A177-3AD203B41FA5}">
                      <a16:colId xmlns:a16="http://schemas.microsoft.com/office/drawing/2014/main" val="1381371333"/>
                    </a:ext>
                  </a:extLst>
                </a:gridCol>
                <a:gridCol w="859267">
                  <a:extLst>
                    <a:ext uri="{9D8B030D-6E8A-4147-A177-3AD203B41FA5}">
                      <a16:colId xmlns:a16="http://schemas.microsoft.com/office/drawing/2014/main" val="629645074"/>
                    </a:ext>
                  </a:extLst>
                </a:gridCol>
                <a:gridCol w="859267">
                  <a:extLst>
                    <a:ext uri="{9D8B030D-6E8A-4147-A177-3AD203B41FA5}">
                      <a16:colId xmlns:a16="http://schemas.microsoft.com/office/drawing/2014/main" val="177775720"/>
                    </a:ext>
                  </a:extLst>
                </a:gridCol>
                <a:gridCol w="859267">
                  <a:extLst>
                    <a:ext uri="{9D8B030D-6E8A-4147-A177-3AD203B41FA5}">
                      <a16:colId xmlns:a16="http://schemas.microsoft.com/office/drawing/2014/main" val="1143532377"/>
                    </a:ext>
                  </a:extLst>
                </a:gridCol>
                <a:gridCol w="859267">
                  <a:extLst>
                    <a:ext uri="{9D8B030D-6E8A-4147-A177-3AD203B41FA5}">
                      <a16:colId xmlns:a16="http://schemas.microsoft.com/office/drawing/2014/main" val="812299048"/>
                    </a:ext>
                  </a:extLst>
                </a:gridCol>
                <a:gridCol w="859267">
                  <a:extLst>
                    <a:ext uri="{9D8B030D-6E8A-4147-A177-3AD203B41FA5}">
                      <a16:colId xmlns:a16="http://schemas.microsoft.com/office/drawing/2014/main" val="1367447304"/>
                    </a:ext>
                  </a:extLst>
                </a:gridCol>
                <a:gridCol w="859267">
                  <a:extLst>
                    <a:ext uri="{9D8B030D-6E8A-4147-A177-3AD203B41FA5}">
                      <a16:colId xmlns:a16="http://schemas.microsoft.com/office/drawing/2014/main" val="381598281"/>
                    </a:ext>
                  </a:extLst>
                </a:gridCol>
                <a:gridCol w="1145691">
                  <a:extLst>
                    <a:ext uri="{9D8B030D-6E8A-4147-A177-3AD203B41FA5}">
                      <a16:colId xmlns:a16="http://schemas.microsoft.com/office/drawing/2014/main" val="299342289"/>
                    </a:ext>
                  </a:extLst>
                </a:gridCol>
                <a:gridCol w="859267">
                  <a:extLst>
                    <a:ext uri="{9D8B030D-6E8A-4147-A177-3AD203B41FA5}">
                      <a16:colId xmlns:a16="http://schemas.microsoft.com/office/drawing/2014/main" val="2566689659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 assessmen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patient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ffec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ortanc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33322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studie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udy desig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isk of bia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consistenc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directnes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recisio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ther consideration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ext2Qui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nline self-help material (control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lativ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solut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8876781"/>
                  </a:ext>
                </a:extLst>
              </a:tr>
              <a:tr h="0">
                <a:tc gridSpan="1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iochemically confirmed abstinence from smoking (follow up: 6 months; assessed with: biochemically confirmed repeated point prevalence abstinence using level of cotinine (ng/dl)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863269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ndomized trial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9/262 (11.1%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/241 (5.0%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R 2.22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1.16 to 4.26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1 more per 1,000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from 8 more to 162 more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  <a:cs typeface="Cambria" panose="02040503050406030204" pitchFamily="18" charset="0"/>
                        </a:rPr>
                        <a:t>⨁⨁</a:t>
                      </a:r>
                      <a:r>
                        <a:rPr lang="en-US" sz="1100">
                          <a:effectLst/>
                          <a:latin typeface="MS Mincho" panose="02020609040205080304" pitchFamily="49" charset="-128"/>
                          <a:ea typeface="Times New Roman" panose="02020603050405020304" pitchFamily="18" charset="0"/>
                          <a:cs typeface="MS Mincho" panose="02020609040205080304" pitchFamily="49" charset="-128"/>
                        </a:rPr>
                        <a:t>◯◯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2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294527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953735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559399" y="272566"/>
            <a:ext cx="1124174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estion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INCPAD (telecare collaborative management intervention) compared to usual care for cancer patients with at least moderately severe pain and/or depression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tting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16 oncology practices (from 3/2006 through 8/2008): 10 rural/midsize practices staffed by satellite oncology service; 4 large clinics in Indianapolis; 1 clinic for underserved; 1 VA clinic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bliography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2 Kroenke, K 2010 </a:t>
            </a:r>
            <a:endParaRPr lang="en-US" sz="20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838200" y="2007394"/>
          <a:ext cx="10515600" cy="3987800"/>
        </p:xfrm>
        <a:graphic>
          <a:graphicData uri="http://schemas.openxmlformats.org/drawingml/2006/table">
            <a:tbl>
              <a:tblPr firstRow="1" firstCol="1" bandRow="1"/>
              <a:tblGrid>
                <a:gridCol w="788670">
                  <a:extLst>
                    <a:ext uri="{9D8B030D-6E8A-4147-A177-3AD203B41FA5}">
                      <a16:colId xmlns:a16="http://schemas.microsoft.com/office/drawing/2014/main" val="3477110188"/>
                    </a:ext>
                  </a:extLst>
                </a:gridCol>
                <a:gridCol w="788670">
                  <a:extLst>
                    <a:ext uri="{9D8B030D-6E8A-4147-A177-3AD203B41FA5}">
                      <a16:colId xmlns:a16="http://schemas.microsoft.com/office/drawing/2014/main" val="1791043538"/>
                    </a:ext>
                  </a:extLst>
                </a:gridCol>
                <a:gridCol w="788670">
                  <a:extLst>
                    <a:ext uri="{9D8B030D-6E8A-4147-A177-3AD203B41FA5}">
                      <a16:colId xmlns:a16="http://schemas.microsoft.com/office/drawing/2014/main" val="3094298148"/>
                    </a:ext>
                  </a:extLst>
                </a:gridCol>
                <a:gridCol w="788670">
                  <a:extLst>
                    <a:ext uri="{9D8B030D-6E8A-4147-A177-3AD203B41FA5}">
                      <a16:colId xmlns:a16="http://schemas.microsoft.com/office/drawing/2014/main" val="457031190"/>
                    </a:ext>
                  </a:extLst>
                </a:gridCol>
                <a:gridCol w="788670">
                  <a:extLst>
                    <a:ext uri="{9D8B030D-6E8A-4147-A177-3AD203B41FA5}">
                      <a16:colId xmlns:a16="http://schemas.microsoft.com/office/drawing/2014/main" val="3485234003"/>
                    </a:ext>
                  </a:extLst>
                </a:gridCol>
                <a:gridCol w="788670">
                  <a:extLst>
                    <a:ext uri="{9D8B030D-6E8A-4147-A177-3AD203B41FA5}">
                      <a16:colId xmlns:a16="http://schemas.microsoft.com/office/drawing/2014/main" val="1361656625"/>
                    </a:ext>
                  </a:extLst>
                </a:gridCol>
                <a:gridCol w="788670">
                  <a:extLst>
                    <a:ext uri="{9D8B030D-6E8A-4147-A177-3AD203B41FA5}">
                      <a16:colId xmlns:a16="http://schemas.microsoft.com/office/drawing/2014/main" val="1580332515"/>
                    </a:ext>
                  </a:extLst>
                </a:gridCol>
                <a:gridCol w="788670">
                  <a:extLst>
                    <a:ext uri="{9D8B030D-6E8A-4147-A177-3AD203B41FA5}">
                      <a16:colId xmlns:a16="http://schemas.microsoft.com/office/drawing/2014/main" val="1068153265"/>
                    </a:ext>
                  </a:extLst>
                </a:gridCol>
                <a:gridCol w="788670">
                  <a:extLst>
                    <a:ext uri="{9D8B030D-6E8A-4147-A177-3AD203B41FA5}">
                      <a16:colId xmlns:a16="http://schemas.microsoft.com/office/drawing/2014/main" val="1807240698"/>
                    </a:ext>
                  </a:extLst>
                </a:gridCol>
                <a:gridCol w="788670">
                  <a:extLst>
                    <a:ext uri="{9D8B030D-6E8A-4147-A177-3AD203B41FA5}">
                      <a16:colId xmlns:a16="http://schemas.microsoft.com/office/drawing/2014/main" val="1932822316"/>
                    </a:ext>
                  </a:extLst>
                </a:gridCol>
                <a:gridCol w="788670">
                  <a:extLst>
                    <a:ext uri="{9D8B030D-6E8A-4147-A177-3AD203B41FA5}">
                      <a16:colId xmlns:a16="http://schemas.microsoft.com/office/drawing/2014/main" val="1291599924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4128806865"/>
                    </a:ext>
                  </a:extLst>
                </a:gridCol>
                <a:gridCol w="788670">
                  <a:extLst>
                    <a:ext uri="{9D8B030D-6E8A-4147-A177-3AD203B41FA5}">
                      <a16:colId xmlns:a16="http://schemas.microsoft.com/office/drawing/2014/main" val="4143986446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 assessment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patient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ffec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ortanc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27673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studie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udy design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isk of bia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consistenc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directnes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recisio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ther consideration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CPAD (telecare collaborative management intervention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sual car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lativ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solut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14221303"/>
                  </a:ext>
                </a:extLst>
              </a:tr>
              <a:tr h="0">
                <a:tc gridSpan="1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epression Severity Responder [Co-Primary] (50% or greater decrease in HSCL-20 from baseline) (follow up: 12 months; assessed with: Hopkins Symptom Checklist depression scale (HSCL-20) by telephone interview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9382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ndomized trial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3/98 (33.7%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9/104 (27.9%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R 1.21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0.80 to 1.83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 more per 100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from 6 fewer to 23 more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  <a:cs typeface="Cambria" panose="02040503050406030204" pitchFamily="18" charset="0"/>
                        </a:rPr>
                        <a:t>⨁⨁⨁⨁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IGH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1648339"/>
                  </a:ext>
                </a:extLst>
              </a:tr>
              <a:tr h="0">
                <a:tc gridSpan="1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ain Severity Responder [Co-Primary] (30% or greater decrease in BPI severity from baseline) (follow up: 12 months; assessed with: Brief Pain Inventory (BPI)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844272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ndomized trial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6/91 (50.5%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1/89 (34.8%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R 1.45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1.02 to 2.06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 more per 100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from 1 more to 37 more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  <a:cs typeface="Cambria" panose="02040503050406030204" pitchFamily="18" charset="0"/>
                        </a:rPr>
                        <a:t>⨁⨁⨁⨁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IGH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2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403437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285882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463040" y="294081"/>
            <a:ext cx="9057939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estion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My Road Ahead (10-week self-guided online psychological intervention) compared to online forum for men with localized prostate cancer (treated with curative intent within last 5 years) to improve sexual satisfaction and reduce distress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tting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[Australia] patient self-referral (advertisements in newsletters and web sites, postcards, urologists at several universities)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bliography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3 </a:t>
            </a:r>
            <a:r>
              <a:rPr lang="en-US" dirty="0" err="1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Wootten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C, 2016 </a:t>
            </a:r>
            <a:endParaRPr lang="en-US" sz="20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33804916"/>
              </p:ext>
            </p:extLst>
          </p:nvPr>
        </p:nvGraphicFramePr>
        <p:xfrm>
          <a:off x="225910" y="2435459"/>
          <a:ext cx="11338561" cy="3820158"/>
        </p:xfrm>
        <a:graphic>
          <a:graphicData uri="http://schemas.openxmlformats.org/drawingml/2006/table">
            <a:tbl>
              <a:tblPr firstRow="1" firstCol="1" bandRow="1"/>
              <a:tblGrid>
                <a:gridCol w="571577">
                  <a:extLst>
                    <a:ext uri="{9D8B030D-6E8A-4147-A177-3AD203B41FA5}">
                      <a16:colId xmlns:a16="http://schemas.microsoft.com/office/drawing/2014/main" val="310634075"/>
                    </a:ext>
                  </a:extLst>
                </a:gridCol>
                <a:gridCol w="832416">
                  <a:extLst>
                    <a:ext uri="{9D8B030D-6E8A-4147-A177-3AD203B41FA5}">
                      <a16:colId xmlns:a16="http://schemas.microsoft.com/office/drawing/2014/main" val="125794454"/>
                    </a:ext>
                  </a:extLst>
                </a:gridCol>
                <a:gridCol w="714473">
                  <a:extLst>
                    <a:ext uri="{9D8B030D-6E8A-4147-A177-3AD203B41FA5}">
                      <a16:colId xmlns:a16="http://schemas.microsoft.com/office/drawing/2014/main" val="4047734137"/>
                    </a:ext>
                  </a:extLst>
                </a:gridCol>
                <a:gridCol w="979848">
                  <a:extLst>
                    <a:ext uri="{9D8B030D-6E8A-4147-A177-3AD203B41FA5}">
                      <a16:colId xmlns:a16="http://schemas.microsoft.com/office/drawing/2014/main" val="990771112"/>
                    </a:ext>
                  </a:extLst>
                </a:gridCol>
                <a:gridCol w="880048">
                  <a:extLst>
                    <a:ext uri="{9D8B030D-6E8A-4147-A177-3AD203B41FA5}">
                      <a16:colId xmlns:a16="http://schemas.microsoft.com/office/drawing/2014/main" val="1309593347"/>
                    </a:ext>
                  </a:extLst>
                </a:gridCol>
                <a:gridCol w="843758">
                  <a:extLst>
                    <a:ext uri="{9D8B030D-6E8A-4147-A177-3AD203B41FA5}">
                      <a16:colId xmlns:a16="http://schemas.microsoft.com/office/drawing/2014/main" val="3266195224"/>
                    </a:ext>
                  </a:extLst>
                </a:gridCol>
                <a:gridCol w="1168104">
                  <a:extLst>
                    <a:ext uri="{9D8B030D-6E8A-4147-A177-3AD203B41FA5}">
                      <a16:colId xmlns:a16="http://schemas.microsoft.com/office/drawing/2014/main" val="3459922603"/>
                    </a:ext>
                  </a:extLst>
                </a:gridCol>
                <a:gridCol w="979848">
                  <a:extLst>
                    <a:ext uri="{9D8B030D-6E8A-4147-A177-3AD203B41FA5}">
                      <a16:colId xmlns:a16="http://schemas.microsoft.com/office/drawing/2014/main" val="2415055202"/>
                    </a:ext>
                  </a:extLst>
                </a:gridCol>
                <a:gridCol w="827881">
                  <a:extLst>
                    <a:ext uri="{9D8B030D-6E8A-4147-A177-3AD203B41FA5}">
                      <a16:colId xmlns:a16="http://schemas.microsoft.com/office/drawing/2014/main" val="3555371832"/>
                    </a:ext>
                  </a:extLst>
                </a:gridCol>
                <a:gridCol w="827881">
                  <a:extLst>
                    <a:ext uri="{9D8B030D-6E8A-4147-A177-3AD203B41FA5}">
                      <a16:colId xmlns:a16="http://schemas.microsoft.com/office/drawing/2014/main" val="1656559946"/>
                    </a:ext>
                  </a:extLst>
                </a:gridCol>
                <a:gridCol w="873244">
                  <a:extLst>
                    <a:ext uri="{9D8B030D-6E8A-4147-A177-3AD203B41FA5}">
                      <a16:colId xmlns:a16="http://schemas.microsoft.com/office/drawing/2014/main" val="2614500940"/>
                    </a:ext>
                  </a:extLst>
                </a:gridCol>
                <a:gridCol w="784786">
                  <a:extLst>
                    <a:ext uri="{9D8B030D-6E8A-4147-A177-3AD203B41FA5}">
                      <a16:colId xmlns:a16="http://schemas.microsoft.com/office/drawing/2014/main" val="2015874492"/>
                    </a:ext>
                  </a:extLst>
                </a:gridCol>
                <a:gridCol w="1054697">
                  <a:extLst>
                    <a:ext uri="{9D8B030D-6E8A-4147-A177-3AD203B41FA5}">
                      <a16:colId xmlns:a16="http://schemas.microsoft.com/office/drawing/2014/main" val="3646443736"/>
                    </a:ext>
                  </a:extLst>
                </a:gridCol>
              </a:tblGrid>
              <a:tr h="262890">
                <a:tc gridSpan="7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 assessmen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patient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ffec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ortanc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57007181"/>
                  </a:ext>
                </a:extLst>
              </a:tr>
              <a:tr h="110108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studie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udy desig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isk of bia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consistenc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directnes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recisio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ther consideration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y Road Ahead (10-week self-guided online psychological intervention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nline forum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lativ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solut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01947167"/>
                  </a:ext>
                </a:extLst>
              </a:tr>
              <a:tr h="262890">
                <a:tc gridSpan="1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sychological distress (follow up: 6 months; assessed with: 21-Question Depression, Anxiety, and Stress Scale short version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43477653"/>
                  </a:ext>
                </a:extLst>
              </a:tr>
              <a:tr h="79756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ndomized trial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5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6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an </a:t>
                      </a: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.8 points lower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16.7 lower to 0.9 lower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  <a:cs typeface="Cambria" panose="02040503050406030204" pitchFamily="18" charset="0"/>
                        </a:rPr>
                        <a:t>⨁⨁</a:t>
                      </a:r>
                      <a:r>
                        <a:rPr lang="en-US" sz="1100">
                          <a:effectLst/>
                          <a:latin typeface="MS Mincho" panose="02020609040205080304" pitchFamily="49" charset="-128"/>
                          <a:ea typeface="Times New Roman" panose="02020603050405020304" pitchFamily="18" charset="0"/>
                          <a:cs typeface="MS Mincho" panose="02020609040205080304" pitchFamily="49" charset="-128"/>
                        </a:rPr>
                        <a:t>◯◯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2229913"/>
                  </a:ext>
                </a:extLst>
              </a:tr>
              <a:tr h="262890">
                <a:tc gridSpan="1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xual Satisfaction (follow up: 6 months; assessed with: International Index of Erectile Function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4920840"/>
                  </a:ext>
                </a:extLst>
              </a:tr>
              <a:tr h="1132839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ndomized trial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5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6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an </a:t>
                      </a: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24 points higher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0.25 higher to 2.22 higher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  <a:cs typeface="Cambria" panose="02040503050406030204" pitchFamily="18" charset="0"/>
                        </a:rPr>
                        <a:t>⨁⨁</a:t>
                      </a:r>
                      <a:r>
                        <a:rPr lang="en-US" sz="1100">
                          <a:effectLst/>
                          <a:latin typeface="MS Mincho" panose="02020609040205080304" pitchFamily="49" charset="-128"/>
                          <a:ea typeface="Times New Roman" panose="02020603050405020304" pitchFamily="18" charset="0"/>
                          <a:cs typeface="MS Mincho" panose="02020609040205080304" pitchFamily="49" charset="-128"/>
                        </a:rPr>
                        <a:t>◯◯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2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954869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813001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151067" y="1065932"/>
            <a:ext cx="963885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estion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E-CUIDATE </a:t>
            </a:r>
            <a:r>
              <a:rPr lang="en-US" dirty="0" err="1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elerehab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ystem compared to usual care for stage I-IIIA breast cancer survivors who have completed adjuvant therapy (except hormone treatment)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tting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Oncology and Breast Unit in Granada, Spain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bliography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4 </a:t>
            </a:r>
            <a:r>
              <a:rPr lang="en-US" dirty="0" err="1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liano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-Castillo N, 2016 </a:t>
            </a:r>
            <a:endParaRPr lang="en-US" sz="20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1707669"/>
              </p:ext>
            </p:extLst>
          </p:nvPr>
        </p:nvGraphicFramePr>
        <p:xfrm>
          <a:off x="403408" y="2872899"/>
          <a:ext cx="11478415" cy="1921510"/>
        </p:xfrm>
        <a:graphic>
          <a:graphicData uri="http://schemas.openxmlformats.org/drawingml/2006/table">
            <a:tbl>
              <a:tblPr firstRow="1" firstCol="1" bandRow="1"/>
              <a:tblGrid>
                <a:gridCol w="860881">
                  <a:extLst>
                    <a:ext uri="{9D8B030D-6E8A-4147-A177-3AD203B41FA5}">
                      <a16:colId xmlns:a16="http://schemas.microsoft.com/office/drawing/2014/main" val="874799082"/>
                    </a:ext>
                  </a:extLst>
                </a:gridCol>
                <a:gridCol w="860881">
                  <a:extLst>
                    <a:ext uri="{9D8B030D-6E8A-4147-A177-3AD203B41FA5}">
                      <a16:colId xmlns:a16="http://schemas.microsoft.com/office/drawing/2014/main" val="4224938377"/>
                    </a:ext>
                  </a:extLst>
                </a:gridCol>
                <a:gridCol w="860881">
                  <a:extLst>
                    <a:ext uri="{9D8B030D-6E8A-4147-A177-3AD203B41FA5}">
                      <a16:colId xmlns:a16="http://schemas.microsoft.com/office/drawing/2014/main" val="3921409736"/>
                    </a:ext>
                  </a:extLst>
                </a:gridCol>
                <a:gridCol w="860881">
                  <a:extLst>
                    <a:ext uri="{9D8B030D-6E8A-4147-A177-3AD203B41FA5}">
                      <a16:colId xmlns:a16="http://schemas.microsoft.com/office/drawing/2014/main" val="2191648868"/>
                    </a:ext>
                  </a:extLst>
                </a:gridCol>
                <a:gridCol w="860881">
                  <a:extLst>
                    <a:ext uri="{9D8B030D-6E8A-4147-A177-3AD203B41FA5}">
                      <a16:colId xmlns:a16="http://schemas.microsoft.com/office/drawing/2014/main" val="1665292765"/>
                    </a:ext>
                  </a:extLst>
                </a:gridCol>
                <a:gridCol w="860881">
                  <a:extLst>
                    <a:ext uri="{9D8B030D-6E8A-4147-A177-3AD203B41FA5}">
                      <a16:colId xmlns:a16="http://schemas.microsoft.com/office/drawing/2014/main" val="4142101102"/>
                    </a:ext>
                  </a:extLst>
                </a:gridCol>
                <a:gridCol w="860881">
                  <a:extLst>
                    <a:ext uri="{9D8B030D-6E8A-4147-A177-3AD203B41FA5}">
                      <a16:colId xmlns:a16="http://schemas.microsoft.com/office/drawing/2014/main" val="3633043732"/>
                    </a:ext>
                  </a:extLst>
                </a:gridCol>
                <a:gridCol w="860881">
                  <a:extLst>
                    <a:ext uri="{9D8B030D-6E8A-4147-A177-3AD203B41FA5}">
                      <a16:colId xmlns:a16="http://schemas.microsoft.com/office/drawing/2014/main" val="2336175454"/>
                    </a:ext>
                  </a:extLst>
                </a:gridCol>
                <a:gridCol w="860881">
                  <a:extLst>
                    <a:ext uri="{9D8B030D-6E8A-4147-A177-3AD203B41FA5}">
                      <a16:colId xmlns:a16="http://schemas.microsoft.com/office/drawing/2014/main" val="208025442"/>
                    </a:ext>
                  </a:extLst>
                </a:gridCol>
                <a:gridCol w="860881">
                  <a:extLst>
                    <a:ext uri="{9D8B030D-6E8A-4147-A177-3AD203B41FA5}">
                      <a16:colId xmlns:a16="http://schemas.microsoft.com/office/drawing/2014/main" val="3798091489"/>
                    </a:ext>
                  </a:extLst>
                </a:gridCol>
                <a:gridCol w="860881">
                  <a:extLst>
                    <a:ext uri="{9D8B030D-6E8A-4147-A177-3AD203B41FA5}">
                      <a16:colId xmlns:a16="http://schemas.microsoft.com/office/drawing/2014/main" val="369850194"/>
                    </a:ext>
                  </a:extLst>
                </a:gridCol>
                <a:gridCol w="1147843">
                  <a:extLst>
                    <a:ext uri="{9D8B030D-6E8A-4147-A177-3AD203B41FA5}">
                      <a16:colId xmlns:a16="http://schemas.microsoft.com/office/drawing/2014/main" val="1029471571"/>
                    </a:ext>
                  </a:extLst>
                </a:gridCol>
                <a:gridCol w="860881">
                  <a:extLst>
                    <a:ext uri="{9D8B030D-6E8A-4147-A177-3AD203B41FA5}">
                      <a16:colId xmlns:a16="http://schemas.microsoft.com/office/drawing/2014/main" val="2775048160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 assessmen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patient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ffec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ortanc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66019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studie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udy desig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isk of bia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consistenc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directness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recisio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ther consideration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-CUIDATE telerehab system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sual car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lativ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solut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49879002"/>
                  </a:ext>
                </a:extLst>
              </a:tr>
              <a:tr h="0">
                <a:tc gridSpan="1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lobal health status (follow up: 6 months; assessed with: EORTC QLQ-C30 (Spanish)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068049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ndomized trial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0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1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an </a:t>
                      </a: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1.19 points higher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2.9 higher to 19.49 higher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  <a:cs typeface="Cambria" panose="02040503050406030204" pitchFamily="18" charset="0"/>
                        </a:rPr>
                        <a:t>⨁⨁</a:t>
                      </a:r>
                      <a:r>
                        <a:rPr lang="en-US" sz="1100">
                          <a:effectLst/>
                          <a:latin typeface="MS Mincho" panose="02020609040205080304" pitchFamily="49" charset="-128"/>
                          <a:ea typeface="Times New Roman" panose="02020603050405020304" pitchFamily="18" charset="0"/>
                          <a:cs typeface="MS Mincho" panose="02020609040205080304" pitchFamily="49" charset="-128"/>
                        </a:rPr>
                        <a:t>◯◯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2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538094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26637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323191" y="659842"/>
            <a:ext cx="9735669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estion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Automated symptom monitoring via IVR coupled with e-mail feedback to clinicians about moderate to severe symptoms compared to automated monitoring and usual symptom care for patients who recently (&lt; 4 weeks) underwent thoracotomy for primary lung cancer or lung metastasis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tting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University of Texas MD Anderson Cancer Center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bliography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5 </a:t>
            </a:r>
            <a:r>
              <a:rPr lang="en-US" dirty="0" err="1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leeland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S, 2011 </a:t>
            </a:r>
            <a:endParaRPr lang="en-US" sz="20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96850286"/>
              </p:ext>
            </p:extLst>
          </p:nvPr>
        </p:nvGraphicFramePr>
        <p:xfrm>
          <a:off x="365754" y="2542101"/>
          <a:ext cx="11446145" cy="3262630"/>
        </p:xfrm>
        <a:graphic>
          <a:graphicData uri="http://schemas.openxmlformats.org/drawingml/2006/table">
            <a:tbl>
              <a:tblPr firstRow="1" firstCol="1" bandRow="1"/>
              <a:tblGrid>
                <a:gridCol w="858461">
                  <a:extLst>
                    <a:ext uri="{9D8B030D-6E8A-4147-A177-3AD203B41FA5}">
                      <a16:colId xmlns:a16="http://schemas.microsoft.com/office/drawing/2014/main" val="1720150510"/>
                    </a:ext>
                  </a:extLst>
                </a:gridCol>
                <a:gridCol w="858461">
                  <a:extLst>
                    <a:ext uri="{9D8B030D-6E8A-4147-A177-3AD203B41FA5}">
                      <a16:colId xmlns:a16="http://schemas.microsoft.com/office/drawing/2014/main" val="2517079075"/>
                    </a:ext>
                  </a:extLst>
                </a:gridCol>
                <a:gridCol w="858461">
                  <a:extLst>
                    <a:ext uri="{9D8B030D-6E8A-4147-A177-3AD203B41FA5}">
                      <a16:colId xmlns:a16="http://schemas.microsoft.com/office/drawing/2014/main" val="2295456823"/>
                    </a:ext>
                  </a:extLst>
                </a:gridCol>
                <a:gridCol w="858461">
                  <a:extLst>
                    <a:ext uri="{9D8B030D-6E8A-4147-A177-3AD203B41FA5}">
                      <a16:colId xmlns:a16="http://schemas.microsoft.com/office/drawing/2014/main" val="283012550"/>
                    </a:ext>
                  </a:extLst>
                </a:gridCol>
                <a:gridCol w="858461">
                  <a:extLst>
                    <a:ext uri="{9D8B030D-6E8A-4147-A177-3AD203B41FA5}">
                      <a16:colId xmlns:a16="http://schemas.microsoft.com/office/drawing/2014/main" val="2359961027"/>
                    </a:ext>
                  </a:extLst>
                </a:gridCol>
                <a:gridCol w="858461">
                  <a:extLst>
                    <a:ext uri="{9D8B030D-6E8A-4147-A177-3AD203B41FA5}">
                      <a16:colId xmlns:a16="http://schemas.microsoft.com/office/drawing/2014/main" val="4254120534"/>
                    </a:ext>
                  </a:extLst>
                </a:gridCol>
                <a:gridCol w="858461">
                  <a:extLst>
                    <a:ext uri="{9D8B030D-6E8A-4147-A177-3AD203B41FA5}">
                      <a16:colId xmlns:a16="http://schemas.microsoft.com/office/drawing/2014/main" val="3308920184"/>
                    </a:ext>
                  </a:extLst>
                </a:gridCol>
                <a:gridCol w="858461">
                  <a:extLst>
                    <a:ext uri="{9D8B030D-6E8A-4147-A177-3AD203B41FA5}">
                      <a16:colId xmlns:a16="http://schemas.microsoft.com/office/drawing/2014/main" val="1447647833"/>
                    </a:ext>
                  </a:extLst>
                </a:gridCol>
                <a:gridCol w="858461">
                  <a:extLst>
                    <a:ext uri="{9D8B030D-6E8A-4147-A177-3AD203B41FA5}">
                      <a16:colId xmlns:a16="http://schemas.microsoft.com/office/drawing/2014/main" val="435349155"/>
                    </a:ext>
                  </a:extLst>
                </a:gridCol>
                <a:gridCol w="858461">
                  <a:extLst>
                    <a:ext uri="{9D8B030D-6E8A-4147-A177-3AD203B41FA5}">
                      <a16:colId xmlns:a16="http://schemas.microsoft.com/office/drawing/2014/main" val="385393094"/>
                    </a:ext>
                  </a:extLst>
                </a:gridCol>
                <a:gridCol w="858461">
                  <a:extLst>
                    <a:ext uri="{9D8B030D-6E8A-4147-A177-3AD203B41FA5}">
                      <a16:colId xmlns:a16="http://schemas.microsoft.com/office/drawing/2014/main" val="1977211895"/>
                    </a:ext>
                  </a:extLst>
                </a:gridCol>
                <a:gridCol w="1144613">
                  <a:extLst>
                    <a:ext uri="{9D8B030D-6E8A-4147-A177-3AD203B41FA5}">
                      <a16:colId xmlns:a16="http://schemas.microsoft.com/office/drawing/2014/main" val="213763157"/>
                    </a:ext>
                  </a:extLst>
                </a:gridCol>
                <a:gridCol w="858461">
                  <a:extLst>
                    <a:ext uri="{9D8B030D-6E8A-4147-A177-3AD203B41FA5}">
                      <a16:colId xmlns:a16="http://schemas.microsoft.com/office/drawing/2014/main" val="684871374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 assessmen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patient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ffec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ortanc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17018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studie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udy desig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isk of bia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consistenc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directnes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recisio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ther consideration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utomated symptom monitoring via IVR coupled with e-mail feedback to clinicians about moderate to severe symptom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utomated monitoring and usual symptom car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lativ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solut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0847053"/>
                  </a:ext>
                </a:extLst>
              </a:tr>
              <a:tr h="0">
                <a:tc gridSpan="1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an Symptom Threshold Events Per Patient (follow up: 4 weeks; assessed with: MD Anderson Symptom Inventory (pain, distress, disturbed sleep, shortness of breath)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7160559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ndomized trial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ery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2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R 0.88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0.78 to 0.98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 fewer per 1,000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from -- to --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  <a:cs typeface="Cambria" panose="02040503050406030204" pitchFamily="18" charset="0"/>
                        </a:rPr>
                        <a:t>⨁</a:t>
                      </a:r>
                      <a:r>
                        <a:rPr lang="en-US" sz="1100">
                          <a:effectLst/>
                          <a:latin typeface="MS Mincho" panose="02020609040205080304" pitchFamily="49" charset="-128"/>
                          <a:ea typeface="Times New Roman" panose="02020603050405020304" pitchFamily="18" charset="0"/>
                          <a:cs typeface="MS Mincho" panose="02020609040205080304" pitchFamily="49" charset="-128"/>
                        </a:rPr>
                        <a:t>◯◯◯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ERY LOW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2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10969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49217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129553" y="915325"/>
            <a:ext cx="938066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estion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STAR (systematic web-based collection of PROs with automated alerts to clinical team) compared to usual care for patients receiving routine outpatient chemotherapy for advanced solid tumors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tting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Memorial Sloan Kettering Cancer Center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bliography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6 </a:t>
            </a:r>
            <a:r>
              <a:rPr lang="en-US" dirty="0" err="1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sch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, 2015 </a:t>
            </a:r>
            <a:endParaRPr lang="en-US" sz="20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86492425"/>
              </p:ext>
            </p:extLst>
          </p:nvPr>
        </p:nvGraphicFramePr>
        <p:xfrm>
          <a:off x="247427" y="2537619"/>
          <a:ext cx="11456893" cy="2759710"/>
        </p:xfrm>
        <a:graphic>
          <a:graphicData uri="http://schemas.openxmlformats.org/drawingml/2006/table">
            <a:tbl>
              <a:tblPr firstRow="1" firstCol="1" bandRow="1"/>
              <a:tblGrid>
                <a:gridCol w="859267">
                  <a:extLst>
                    <a:ext uri="{9D8B030D-6E8A-4147-A177-3AD203B41FA5}">
                      <a16:colId xmlns:a16="http://schemas.microsoft.com/office/drawing/2014/main" val="2950892739"/>
                    </a:ext>
                  </a:extLst>
                </a:gridCol>
                <a:gridCol w="859267">
                  <a:extLst>
                    <a:ext uri="{9D8B030D-6E8A-4147-A177-3AD203B41FA5}">
                      <a16:colId xmlns:a16="http://schemas.microsoft.com/office/drawing/2014/main" val="2643089154"/>
                    </a:ext>
                  </a:extLst>
                </a:gridCol>
                <a:gridCol w="859267">
                  <a:extLst>
                    <a:ext uri="{9D8B030D-6E8A-4147-A177-3AD203B41FA5}">
                      <a16:colId xmlns:a16="http://schemas.microsoft.com/office/drawing/2014/main" val="3783628851"/>
                    </a:ext>
                  </a:extLst>
                </a:gridCol>
                <a:gridCol w="859267">
                  <a:extLst>
                    <a:ext uri="{9D8B030D-6E8A-4147-A177-3AD203B41FA5}">
                      <a16:colId xmlns:a16="http://schemas.microsoft.com/office/drawing/2014/main" val="2034399119"/>
                    </a:ext>
                  </a:extLst>
                </a:gridCol>
                <a:gridCol w="859267">
                  <a:extLst>
                    <a:ext uri="{9D8B030D-6E8A-4147-A177-3AD203B41FA5}">
                      <a16:colId xmlns:a16="http://schemas.microsoft.com/office/drawing/2014/main" val="950045327"/>
                    </a:ext>
                  </a:extLst>
                </a:gridCol>
                <a:gridCol w="859267">
                  <a:extLst>
                    <a:ext uri="{9D8B030D-6E8A-4147-A177-3AD203B41FA5}">
                      <a16:colId xmlns:a16="http://schemas.microsoft.com/office/drawing/2014/main" val="2157400266"/>
                    </a:ext>
                  </a:extLst>
                </a:gridCol>
                <a:gridCol w="859267">
                  <a:extLst>
                    <a:ext uri="{9D8B030D-6E8A-4147-A177-3AD203B41FA5}">
                      <a16:colId xmlns:a16="http://schemas.microsoft.com/office/drawing/2014/main" val="2888907740"/>
                    </a:ext>
                  </a:extLst>
                </a:gridCol>
                <a:gridCol w="859267">
                  <a:extLst>
                    <a:ext uri="{9D8B030D-6E8A-4147-A177-3AD203B41FA5}">
                      <a16:colId xmlns:a16="http://schemas.microsoft.com/office/drawing/2014/main" val="496660365"/>
                    </a:ext>
                  </a:extLst>
                </a:gridCol>
                <a:gridCol w="859267">
                  <a:extLst>
                    <a:ext uri="{9D8B030D-6E8A-4147-A177-3AD203B41FA5}">
                      <a16:colId xmlns:a16="http://schemas.microsoft.com/office/drawing/2014/main" val="670460012"/>
                    </a:ext>
                  </a:extLst>
                </a:gridCol>
                <a:gridCol w="859267">
                  <a:extLst>
                    <a:ext uri="{9D8B030D-6E8A-4147-A177-3AD203B41FA5}">
                      <a16:colId xmlns:a16="http://schemas.microsoft.com/office/drawing/2014/main" val="232315137"/>
                    </a:ext>
                  </a:extLst>
                </a:gridCol>
                <a:gridCol w="859267">
                  <a:extLst>
                    <a:ext uri="{9D8B030D-6E8A-4147-A177-3AD203B41FA5}">
                      <a16:colId xmlns:a16="http://schemas.microsoft.com/office/drawing/2014/main" val="1373388092"/>
                    </a:ext>
                  </a:extLst>
                </a:gridCol>
                <a:gridCol w="1145689">
                  <a:extLst>
                    <a:ext uri="{9D8B030D-6E8A-4147-A177-3AD203B41FA5}">
                      <a16:colId xmlns:a16="http://schemas.microsoft.com/office/drawing/2014/main" val="1139499626"/>
                    </a:ext>
                  </a:extLst>
                </a:gridCol>
                <a:gridCol w="859267">
                  <a:extLst>
                    <a:ext uri="{9D8B030D-6E8A-4147-A177-3AD203B41FA5}">
                      <a16:colId xmlns:a16="http://schemas.microsoft.com/office/drawing/2014/main" val="635615850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 assessmen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patient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ffec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ortanc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14540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studie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udy desig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isk of bia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consistenc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directnes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recisio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ther consideration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AR (systematic web-based collection of PROs with automated alerts to clinical team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sual car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lativ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solut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37057249"/>
                  </a:ext>
                </a:extLst>
              </a:tr>
              <a:tr h="0">
                <a:tc gridSpan="1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linically Meaningful Worsening of Health-Related Quality of Life at 6 months (Worsened by 6 or more points) (follow up: 6 months; assessed with: EuroQoL EQ-5D Index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598650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ndomized trial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8/277 (28.2%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5/180 (36.1%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estimable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 fewer per 100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from 0 more to 16 fewer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  <a:cs typeface="Cambria" panose="02040503050406030204" pitchFamily="18" charset="0"/>
                        </a:rPr>
                        <a:t>⨁⨁</a:t>
                      </a:r>
                      <a:r>
                        <a:rPr lang="en-US" sz="1100">
                          <a:effectLst/>
                          <a:latin typeface="MS Mincho" panose="02020609040205080304" pitchFamily="49" charset="-128"/>
                          <a:ea typeface="Times New Roman" panose="02020603050405020304" pitchFamily="18" charset="0"/>
                          <a:cs typeface="MS Mincho" panose="02020609040205080304" pitchFamily="49" charset="-128"/>
                        </a:rPr>
                        <a:t>◯◯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2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21519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231512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102659" y="671949"/>
            <a:ext cx="9821732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estion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Should SCH (Symptom Care at Home automated symptom management system) compared to enhanced usual care for patients beginning chemotherapy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tting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four oncology practices at a cancer center in the Intermountain West and two oncology practices at a public hospital associated with a comprehensive cancer center partnership in the South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bliography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7 Mooney KH, 2016 </a:t>
            </a:r>
            <a:endParaRPr lang="en-US" sz="20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40578261"/>
              </p:ext>
            </p:extLst>
          </p:nvPr>
        </p:nvGraphicFramePr>
        <p:xfrm>
          <a:off x="236671" y="2705259"/>
          <a:ext cx="11553709" cy="2424430"/>
        </p:xfrm>
        <a:graphic>
          <a:graphicData uri="http://schemas.openxmlformats.org/drawingml/2006/table">
            <a:tbl>
              <a:tblPr firstRow="1" firstCol="1" bandRow="1"/>
              <a:tblGrid>
                <a:gridCol w="866528">
                  <a:extLst>
                    <a:ext uri="{9D8B030D-6E8A-4147-A177-3AD203B41FA5}">
                      <a16:colId xmlns:a16="http://schemas.microsoft.com/office/drawing/2014/main" val="3346035481"/>
                    </a:ext>
                  </a:extLst>
                </a:gridCol>
                <a:gridCol w="866528">
                  <a:extLst>
                    <a:ext uri="{9D8B030D-6E8A-4147-A177-3AD203B41FA5}">
                      <a16:colId xmlns:a16="http://schemas.microsoft.com/office/drawing/2014/main" val="4173391345"/>
                    </a:ext>
                  </a:extLst>
                </a:gridCol>
                <a:gridCol w="866528">
                  <a:extLst>
                    <a:ext uri="{9D8B030D-6E8A-4147-A177-3AD203B41FA5}">
                      <a16:colId xmlns:a16="http://schemas.microsoft.com/office/drawing/2014/main" val="1164113747"/>
                    </a:ext>
                  </a:extLst>
                </a:gridCol>
                <a:gridCol w="866528">
                  <a:extLst>
                    <a:ext uri="{9D8B030D-6E8A-4147-A177-3AD203B41FA5}">
                      <a16:colId xmlns:a16="http://schemas.microsoft.com/office/drawing/2014/main" val="539011688"/>
                    </a:ext>
                  </a:extLst>
                </a:gridCol>
                <a:gridCol w="866528">
                  <a:extLst>
                    <a:ext uri="{9D8B030D-6E8A-4147-A177-3AD203B41FA5}">
                      <a16:colId xmlns:a16="http://schemas.microsoft.com/office/drawing/2014/main" val="3587453312"/>
                    </a:ext>
                  </a:extLst>
                </a:gridCol>
                <a:gridCol w="866528">
                  <a:extLst>
                    <a:ext uri="{9D8B030D-6E8A-4147-A177-3AD203B41FA5}">
                      <a16:colId xmlns:a16="http://schemas.microsoft.com/office/drawing/2014/main" val="1782549736"/>
                    </a:ext>
                  </a:extLst>
                </a:gridCol>
                <a:gridCol w="866528">
                  <a:extLst>
                    <a:ext uri="{9D8B030D-6E8A-4147-A177-3AD203B41FA5}">
                      <a16:colId xmlns:a16="http://schemas.microsoft.com/office/drawing/2014/main" val="1088547511"/>
                    </a:ext>
                  </a:extLst>
                </a:gridCol>
                <a:gridCol w="866528">
                  <a:extLst>
                    <a:ext uri="{9D8B030D-6E8A-4147-A177-3AD203B41FA5}">
                      <a16:colId xmlns:a16="http://schemas.microsoft.com/office/drawing/2014/main" val="648459721"/>
                    </a:ext>
                  </a:extLst>
                </a:gridCol>
                <a:gridCol w="866528">
                  <a:extLst>
                    <a:ext uri="{9D8B030D-6E8A-4147-A177-3AD203B41FA5}">
                      <a16:colId xmlns:a16="http://schemas.microsoft.com/office/drawing/2014/main" val="3159798477"/>
                    </a:ext>
                  </a:extLst>
                </a:gridCol>
                <a:gridCol w="866528">
                  <a:extLst>
                    <a:ext uri="{9D8B030D-6E8A-4147-A177-3AD203B41FA5}">
                      <a16:colId xmlns:a16="http://schemas.microsoft.com/office/drawing/2014/main" val="3774744948"/>
                    </a:ext>
                  </a:extLst>
                </a:gridCol>
                <a:gridCol w="866528">
                  <a:extLst>
                    <a:ext uri="{9D8B030D-6E8A-4147-A177-3AD203B41FA5}">
                      <a16:colId xmlns:a16="http://schemas.microsoft.com/office/drawing/2014/main" val="2230634174"/>
                    </a:ext>
                  </a:extLst>
                </a:gridCol>
                <a:gridCol w="1155373">
                  <a:extLst>
                    <a:ext uri="{9D8B030D-6E8A-4147-A177-3AD203B41FA5}">
                      <a16:colId xmlns:a16="http://schemas.microsoft.com/office/drawing/2014/main" val="3488287521"/>
                    </a:ext>
                  </a:extLst>
                </a:gridCol>
                <a:gridCol w="866528">
                  <a:extLst>
                    <a:ext uri="{9D8B030D-6E8A-4147-A177-3AD203B41FA5}">
                      <a16:colId xmlns:a16="http://schemas.microsoft.com/office/drawing/2014/main" val="1513712915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 assessmen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patient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ffec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ortanc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86904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studie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udy desig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isk of bia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consistenc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directnes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recisio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ther consideration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hould SCH (Symptom Care at Home automated symptom management system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nhanced usual car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lativ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solut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46821375"/>
                  </a:ext>
                </a:extLst>
              </a:tr>
              <a:tr h="0">
                <a:tc gridSpan="1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days with severe symptoms (follow up: 6 months; assessed with: Sum of 0-10 severity ratings across 11 symptoms reports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136368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ndomized trial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80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8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an </a:t>
                      </a: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1.29 days fewer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0 to 0 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  <a:cs typeface="Cambria" panose="02040503050406030204" pitchFamily="18" charset="0"/>
                        </a:rPr>
                        <a:t>⨁⨁</a:t>
                      </a:r>
                      <a:r>
                        <a:rPr lang="en-US" sz="1100">
                          <a:effectLst/>
                          <a:latin typeface="MS Mincho" panose="02020609040205080304" pitchFamily="49" charset="-128"/>
                          <a:ea typeface="Times New Roman" panose="02020603050405020304" pitchFamily="18" charset="0"/>
                          <a:cs typeface="MS Mincho" panose="02020609040205080304" pitchFamily="49" charset="-128"/>
                        </a:rPr>
                        <a:t>◯◯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2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375768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4412449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065007" y="308889"/>
            <a:ext cx="10144461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estion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Automated telephone symptom management (ATSM) intervention (delivers a standard message focused on patients’ symptoms) compared to nurse-assisted symptom management (NASM) intervention (delivered by telephone by trained cancer nurses) for patients diagnosis of a solid tumor cancer or non-Hodgkin’s lymphoma and undergoing a course of chemotherapy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tting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a sponsoring university, 2 comprehensive cancer centers, one community cancer oncology program, and six hospital-affiliated community oncology centers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bliography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8 </a:t>
            </a:r>
            <a:r>
              <a:rPr lang="en-US" dirty="0" err="1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korskii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, 2007 </a:t>
            </a:r>
            <a:endParaRPr lang="en-US" sz="20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80957617"/>
              </p:ext>
            </p:extLst>
          </p:nvPr>
        </p:nvGraphicFramePr>
        <p:xfrm>
          <a:off x="258179" y="2701224"/>
          <a:ext cx="11478413" cy="3094990"/>
        </p:xfrm>
        <a:graphic>
          <a:graphicData uri="http://schemas.openxmlformats.org/drawingml/2006/table">
            <a:tbl>
              <a:tblPr firstRow="1" firstCol="1" bandRow="1"/>
              <a:tblGrid>
                <a:gridCol w="860881">
                  <a:extLst>
                    <a:ext uri="{9D8B030D-6E8A-4147-A177-3AD203B41FA5}">
                      <a16:colId xmlns:a16="http://schemas.microsoft.com/office/drawing/2014/main" val="4148797121"/>
                    </a:ext>
                  </a:extLst>
                </a:gridCol>
                <a:gridCol w="860881">
                  <a:extLst>
                    <a:ext uri="{9D8B030D-6E8A-4147-A177-3AD203B41FA5}">
                      <a16:colId xmlns:a16="http://schemas.microsoft.com/office/drawing/2014/main" val="2564462840"/>
                    </a:ext>
                  </a:extLst>
                </a:gridCol>
                <a:gridCol w="860881">
                  <a:extLst>
                    <a:ext uri="{9D8B030D-6E8A-4147-A177-3AD203B41FA5}">
                      <a16:colId xmlns:a16="http://schemas.microsoft.com/office/drawing/2014/main" val="639456519"/>
                    </a:ext>
                  </a:extLst>
                </a:gridCol>
                <a:gridCol w="860881">
                  <a:extLst>
                    <a:ext uri="{9D8B030D-6E8A-4147-A177-3AD203B41FA5}">
                      <a16:colId xmlns:a16="http://schemas.microsoft.com/office/drawing/2014/main" val="638804036"/>
                    </a:ext>
                  </a:extLst>
                </a:gridCol>
                <a:gridCol w="860881">
                  <a:extLst>
                    <a:ext uri="{9D8B030D-6E8A-4147-A177-3AD203B41FA5}">
                      <a16:colId xmlns:a16="http://schemas.microsoft.com/office/drawing/2014/main" val="2277941424"/>
                    </a:ext>
                  </a:extLst>
                </a:gridCol>
                <a:gridCol w="860881">
                  <a:extLst>
                    <a:ext uri="{9D8B030D-6E8A-4147-A177-3AD203B41FA5}">
                      <a16:colId xmlns:a16="http://schemas.microsoft.com/office/drawing/2014/main" val="2333723062"/>
                    </a:ext>
                  </a:extLst>
                </a:gridCol>
                <a:gridCol w="860881">
                  <a:extLst>
                    <a:ext uri="{9D8B030D-6E8A-4147-A177-3AD203B41FA5}">
                      <a16:colId xmlns:a16="http://schemas.microsoft.com/office/drawing/2014/main" val="523492898"/>
                    </a:ext>
                  </a:extLst>
                </a:gridCol>
                <a:gridCol w="860881">
                  <a:extLst>
                    <a:ext uri="{9D8B030D-6E8A-4147-A177-3AD203B41FA5}">
                      <a16:colId xmlns:a16="http://schemas.microsoft.com/office/drawing/2014/main" val="2067040895"/>
                    </a:ext>
                  </a:extLst>
                </a:gridCol>
                <a:gridCol w="860881">
                  <a:extLst>
                    <a:ext uri="{9D8B030D-6E8A-4147-A177-3AD203B41FA5}">
                      <a16:colId xmlns:a16="http://schemas.microsoft.com/office/drawing/2014/main" val="4062740040"/>
                    </a:ext>
                  </a:extLst>
                </a:gridCol>
                <a:gridCol w="860881">
                  <a:extLst>
                    <a:ext uri="{9D8B030D-6E8A-4147-A177-3AD203B41FA5}">
                      <a16:colId xmlns:a16="http://schemas.microsoft.com/office/drawing/2014/main" val="3552037817"/>
                    </a:ext>
                  </a:extLst>
                </a:gridCol>
                <a:gridCol w="860881">
                  <a:extLst>
                    <a:ext uri="{9D8B030D-6E8A-4147-A177-3AD203B41FA5}">
                      <a16:colId xmlns:a16="http://schemas.microsoft.com/office/drawing/2014/main" val="65816626"/>
                    </a:ext>
                  </a:extLst>
                </a:gridCol>
                <a:gridCol w="1147841">
                  <a:extLst>
                    <a:ext uri="{9D8B030D-6E8A-4147-A177-3AD203B41FA5}">
                      <a16:colId xmlns:a16="http://schemas.microsoft.com/office/drawing/2014/main" val="186977878"/>
                    </a:ext>
                  </a:extLst>
                </a:gridCol>
                <a:gridCol w="860881">
                  <a:extLst>
                    <a:ext uri="{9D8B030D-6E8A-4147-A177-3AD203B41FA5}">
                      <a16:colId xmlns:a16="http://schemas.microsoft.com/office/drawing/2014/main" val="885897947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 assessmen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patient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ffec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ortanc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06369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studie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udy desig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isk of bia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consistenc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directnes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recisio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ther consideration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utomated telephone symptom management (ATSM) intervention (delivers a standard message focused on patients’ symptoms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urse-assisted symptom management (NASM) intervention (delivered by telephone by trained cancer nurses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lativ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solut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17450734"/>
                  </a:ext>
                </a:extLst>
              </a:tr>
              <a:tr h="0">
                <a:tc gridSpan="1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ymptom Severity (follow up: 10 weeks; assessed with: Severity of 17 symptoms; Scale from: 0 to 10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870468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ndomized trial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ery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19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18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ffect Size </a:t>
                      </a: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 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0 to 0 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  <a:cs typeface="Cambria" panose="02040503050406030204" pitchFamily="18" charset="0"/>
                        </a:rPr>
                        <a:t>⨁⨁</a:t>
                      </a:r>
                      <a:r>
                        <a:rPr lang="en-US" sz="1100">
                          <a:effectLst/>
                          <a:latin typeface="MS Mincho" panose="02020609040205080304" pitchFamily="49" charset="-128"/>
                          <a:ea typeface="Times New Roman" panose="02020603050405020304" pitchFamily="18" charset="0"/>
                          <a:cs typeface="MS Mincho" panose="02020609040205080304" pitchFamily="49" charset="-128"/>
                        </a:rPr>
                        <a:t>◯◯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2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54586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9043196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065009" y="810448"/>
            <a:ext cx="1031658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estion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CHESS (Comprehensive Health Enhancement Online Support System) compared to Internet for patients with advanced non-small cell lung cancer (and clinician-perceived life-expectancy of &gt; 4 months) and their primary caregivers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tting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4 cancer-center hospitals in the East, Midwest, and Southwest US </a:t>
            </a:r>
            <a:endParaRPr lang="en-US" sz="20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bliography</a:t>
            </a:r>
            <a:r>
              <a:rPr lang="en-US" dirty="0">
                <a:solidFill>
                  <a:srgbClr val="000000"/>
                </a:solidFill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9 Gustafson DH, 2013 </a:t>
            </a:r>
            <a:endParaRPr lang="en-US" sz="20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32907650"/>
              </p:ext>
            </p:extLst>
          </p:nvPr>
        </p:nvGraphicFramePr>
        <p:xfrm>
          <a:off x="290460" y="2537619"/>
          <a:ext cx="11435374" cy="2592070"/>
        </p:xfrm>
        <a:graphic>
          <a:graphicData uri="http://schemas.openxmlformats.org/drawingml/2006/table">
            <a:tbl>
              <a:tblPr firstRow="1" firstCol="1" bandRow="1"/>
              <a:tblGrid>
                <a:gridCol w="857653">
                  <a:extLst>
                    <a:ext uri="{9D8B030D-6E8A-4147-A177-3AD203B41FA5}">
                      <a16:colId xmlns:a16="http://schemas.microsoft.com/office/drawing/2014/main" val="1323242951"/>
                    </a:ext>
                  </a:extLst>
                </a:gridCol>
                <a:gridCol w="857653">
                  <a:extLst>
                    <a:ext uri="{9D8B030D-6E8A-4147-A177-3AD203B41FA5}">
                      <a16:colId xmlns:a16="http://schemas.microsoft.com/office/drawing/2014/main" val="3795777212"/>
                    </a:ext>
                  </a:extLst>
                </a:gridCol>
                <a:gridCol w="857653">
                  <a:extLst>
                    <a:ext uri="{9D8B030D-6E8A-4147-A177-3AD203B41FA5}">
                      <a16:colId xmlns:a16="http://schemas.microsoft.com/office/drawing/2014/main" val="2832089214"/>
                    </a:ext>
                  </a:extLst>
                </a:gridCol>
                <a:gridCol w="857653">
                  <a:extLst>
                    <a:ext uri="{9D8B030D-6E8A-4147-A177-3AD203B41FA5}">
                      <a16:colId xmlns:a16="http://schemas.microsoft.com/office/drawing/2014/main" val="3806011912"/>
                    </a:ext>
                  </a:extLst>
                </a:gridCol>
                <a:gridCol w="857653">
                  <a:extLst>
                    <a:ext uri="{9D8B030D-6E8A-4147-A177-3AD203B41FA5}">
                      <a16:colId xmlns:a16="http://schemas.microsoft.com/office/drawing/2014/main" val="2907135666"/>
                    </a:ext>
                  </a:extLst>
                </a:gridCol>
                <a:gridCol w="857653">
                  <a:extLst>
                    <a:ext uri="{9D8B030D-6E8A-4147-A177-3AD203B41FA5}">
                      <a16:colId xmlns:a16="http://schemas.microsoft.com/office/drawing/2014/main" val="3343622967"/>
                    </a:ext>
                  </a:extLst>
                </a:gridCol>
                <a:gridCol w="857653">
                  <a:extLst>
                    <a:ext uri="{9D8B030D-6E8A-4147-A177-3AD203B41FA5}">
                      <a16:colId xmlns:a16="http://schemas.microsoft.com/office/drawing/2014/main" val="31967448"/>
                    </a:ext>
                  </a:extLst>
                </a:gridCol>
                <a:gridCol w="857653">
                  <a:extLst>
                    <a:ext uri="{9D8B030D-6E8A-4147-A177-3AD203B41FA5}">
                      <a16:colId xmlns:a16="http://schemas.microsoft.com/office/drawing/2014/main" val="73024656"/>
                    </a:ext>
                  </a:extLst>
                </a:gridCol>
                <a:gridCol w="857653">
                  <a:extLst>
                    <a:ext uri="{9D8B030D-6E8A-4147-A177-3AD203B41FA5}">
                      <a16:colId xmlns:a16="http://schemas.microsoft.com/office/drawing/2014/main" val="1188197415"/>
                    </a:ext>
                  </a:extLst>
                </a:gridCol>
                <a:gridCol w="857653">
                  <a:extLst>
                    <a:ext uri="{9D8B030D-6E8A-4147-A177-3AD203B41FA5}">
                      <a16:colId xmlns:a16="http://schemas.microsoft.com/office/drawing/2014/main" val="1790827664"/>
                    </a:ext>
                  </a:extLst>
                </a:gridCol>
                <a:gridCol w="857653">
                  <a:extLst>
                    <a:ext uri="{9D8B030D-6E8A-4147-A177-3AD203B41FA5}">
                      <a16:colId xmlns:a16="http://schemas.microsoft.com/office/drawing/2014/main" val="628168530"/>
                    </a:ext>
                  </a:extLst>
                </a:gridCol>
                <a:gridCol w="1143538">
                  <a:extLst>
                    <a:ext uri="{9D8B030D-6E8A-4147-A177-3AD203B41FA5}">
                      <a16:colId xmlns:a16="http://schemas.microsoft.com/office/drawing/2014/main" val="2669833704"/>
                    </a:ext>
                  </a:extLst>
                </a:gridCol>
                <a:gridCol w="857653">
                  <a:extLst>
                    <a:ext uri="{9D8B030D-6E8A-4147-A177-3AD203B41FA5}">
                      <a16:colId xmlns:a16="http://schemas.microsoft.com/office/drawing/2014/main" val="3289482934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 assessmen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patient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ffec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ortanc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830418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№ of studie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udy desig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isk of bia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consistenc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directnes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precision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ther consideration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HESS (Comprehensive Health Enhancement Online Support System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ternet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lativ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solute</a:t>
                      </a:r>
                      <a:b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DDD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31658935"/>
                  </a:ext>
                </a:extLst>
              </a:tr>
              <a:tr h="0">
                <a:tc gridSpan="1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atient Symptom Distress (follow up: 13-25 months; assessed with: Edmonton Symptom Assessment Scale - Physical Symptom Subscale (3 original items replaced with lung cancer-specific items); Scale from: 0 to 70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510678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ndomized trial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ery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seriou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4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1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an </a:t>
                      </a:r>
                      <a:r>
                        <a:rPr lang="en-US" sz="1100" b="1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.28 points lower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1.6 lower to 9 lower)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  <a:cs typeface="Cambria" panose="02040503050406030204" pitchFamily="18" charset="0"/>
                        </a:rPr>
                        <a:t>⨁</a:t>
                      </a:r>
                      <a:r>
                        <a:rPr lang="en-US" sz="1100">
                          <a:effectLst/>
                          <a:latin typeface="MS Mincho" panose="02020609040205080304" pitchFamily="49" charset="-128"/>
                          <a:ea typeface="Times New Roman" panose="02020603050405020304" pitchFamily="18" charset="0"/>
                          <a:cs typeface="MS Mincho" panose="02020609040205080304" pitchFamily="49" charset="-128"/>
                        </a:rPr>
                        <a:t>◯◯◯</a:t>
                      </a: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>
                          <a:effectLst/>
                          <a:latin typeface="Arial Narrow" panose="020B0606020202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ERY LOW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2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0" marR="63500" marT="63500" marB="6350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015537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652099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</TotalTime>
  <Words>2224</Words>
  <Application>Microsoft Office PowerPoint</Application>
  <PresentationFormat>Widescreen</PresentationFormat>
  <Paragraphs>498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22" baseType="lpstr">
      <vt:lpstr>MS Mincho</vt:lpstr>
      <vt:lpstr>Arial</vt:lpstr>
      <vt:lpstr>Arial Narrow</vt:lpstr>
      <vt:lpstr>Calibri</vt:lpstr>
      <vt:lpstr>Calibri Light</vt:lpstr>
      <vt:lpstr>Cambria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Michigan Health Syste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rleigh, Janelle</dc:creator>
  <cp:lastModifiedBy>Burleigh, Janelle</cp:lastModifiedBy>
  <cp:revision>4</cp:revision>
  <dcterms:created xsi:type="dcterms:W3CDTF">2018-01-31T15:59:10Z</dcterms:created>
  <dcterms:modified xsi:type="dcterms:W3CDTF">2018-01-31T18:13:58Z</dcterms:modified>
</cp:coreProperties>
</file>